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0" r:id="rId2"/>
    <p:sldId id="269" r:id="rId3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017" autoAdjust="0"/>
    <p:restoredTop sz="94660"/>
  </p:normalViewPr>
  <p:slideViewPr>
    <p:cSldViewPr snapToGrid="0">
      <p:cViewPr varScale="1">
        <p:scale>
          <a:sx n="74" d="100"/>
          <a:sy n="74" d="100"/>
        </p:scale>
        <p:origin x="-378" y="-9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xmlns="" id="{83BB4D07-EE58-4885-AEC5-36C4CF7CAB5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xmlns="" id="{ACA9E757-D4E3-411C-8B07-520BCD84F4A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xmlns="" id="{756928E9-BD6E-48FD-8B96-1D3F77A26A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2594D0-837C-4DBE-89AB-D13A439C0988}" type="datetimeFigureOut">
              <a:rPr lang="ko-KR" altLang="en-US" smtClean="0"/>
              <a:t>2020-06-21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xmlns="" id="{492E2113-C500-4057-8AB4-4155688C57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xmlns="" id="{F62FDC8D-EEBF-40DF-93EC-4C318D385D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A9362C-50AC-4FD7-949C-9BE5315A804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226527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xmlns="" id="{7C8B8696-082A-4DF7-9A5B-EF02C6369BD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xmlns="" id="{9487737D-4CE3-4EB5-B0FB-9C7B8FE5D04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xmlns="" id="{FBA1ECE7-7B1D-4858-AA6A-EF0A1F44A1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2594D0-837C-4DBE-89AB-D13A439C0988}" type="datetimeFigureOut">
              <a:rPr lang="ko-KR" altLang="en-US" smtClean="0"/>
              <a:t>2020-06-21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xmlns="" id="{2292A888-7AA9-4785-8187-CBBBBAFB69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xmlns="" id="{4A83DE10-81BC-49B4-8DC3-2CF046CC7C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A9362C-50AC-4FD7-949C-9BE5315A804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981752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xmlns="" id="{35506A93-E3F9-4EEC-BAEF-A6D8A1E613C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xmlns="" id="{40156370-0615-4CF2-A85D-5D30FCECC03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xmlns="" id="{CAED0916-CBC1-4E38-B46E-4E2009D87C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2594D0-837C-4DBE-89AB-D13A439C0988}" type="datetimeFigureOut">
              <a:rPr lang="ko-KR" altLang="en-US" smtClean="0"/>
              <a:t>2020-06-21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xmlns="" id="{5BDC405C-A826-4A20-900D-C675C45070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xmlns="" id="{E86481DF-B130-404E-886A-33B6AA0B04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A9362C-50AC-4FD7-949C-9BE5315A804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46221283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obj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t>6/21/2020</a:t>
            </a:fld>
            <a:endParaRPr lang="en-US"/>
          </a:p>
        </p:txBody>
      </p:sp>
      <p:sp>
        <p:nvSpPr>
          <p:cNvPr id="4" name="Holder 4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  <p:extLst>
      <p:ext uri="{BB962C8B-B14F-4D97-AF65-F5344CB8AC3E}">
        <p14:creationId xmlns:p14="http://schemas.microsoft.com/office/powerpoint/2010/main" val="37284223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xmlns="" id="{730B95F3-5802-4951-B856-A9020CD4673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xmlns="" id="{9D678FB6-776E-4F9D-B299-B09E231830D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xmlns="" id="{55066558-0561-4F9D-B588-BD031AF45B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2594D0-837C-4DBE-89AB-D13A439C0988}" type="datetimeFigureOut">
              <a:rPr lang="ko-KR" altLang="en-US" smtClean="0"/>
              <a:t>2020-06-21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xmlns="" id="{12FB685D-34F6-4B22-9FFE-6A89769801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xmlns="" id="{51459355-D050-483D-A182-F6199EBF35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A9362C-50AC-4FD7-949C-9BE5315A804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447082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xmlns="" id="{ABC57F09-AB86-443D-AA3F-F188256021E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xmlns="" id="{946A8F1D-D2EC-4E5D-8E36-A318954B2AA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xmlns="" id="{B1D609CC-DA6B-4C79-ACF9-0705562B98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2594D0-837C-4DBE-89AB-D13A439C0988}" type="datetimeFigureOut">
              <a:rPr lang="ko-KR" altLang="en-US" smtClean="0"/>
              <a:t>2020-06-21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xmlns="" id="{D6577BB3-4655-4CE6-816E-C4A746667C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xmlns="" id="{C6BA6848-9970-43DC-A04A-6A765B0EC1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A9362C-50AC-4FD7-949C-9BE5315A804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259074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xmlns="" id="{E4723E3B-35FA-4445-90D8-B6F3F432D43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xmlns="" id="{BDE53869-C9B5-482D-A8E4-3C1BF684D06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xmlns="" id="{761C9646-751C-4535-BE89-DC796D92CE7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xmlns="" id="{CEF791E7-80C2-479F-9B42-4C7970F29A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2594D0-837C-4DBE-89AB-D13A439C0988}" type="datetimeFigureOut">
              <a:rPr lang="ko-KR" altLang="en-US" smtClean="0"/>
              <a:t>2020-06-21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xmlns="" id="{AAE77D4B-4154-4226-A0EB-391C1883D2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xmlns="" id="{500364F7-BF6A-4AA3-8138-ABA95766D9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A9362C-50AC-4FD7-949C-9BE5315A804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203315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xmlns="" id="{2235CAEB-04A4-4C1E-9BE6-CF5CB39BBBD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xmlns="" id="{F5535E57-4A7C-479E-BC70-FB6ABF0C850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xmlns="" id="{900257EF-FEA8-444E-A6FA-FBF36872099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xmlns="" id="{18EB63CA-D7D1-4153-9F8B-D23ADD97F02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xmlns="" id="{D708AF4B-D011-4C75-9F52-0CB1A942CA5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xmlns="" id="{23797A57-586B-485B-82EF-DD52FEFDD6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2594D0-837C-4DBE-89AB-D13A439C0988}" type="datetimeFigureOut">
              <a:rPr lang="ko-KR" altLang="en-US" smtClean="0"/>
              <a:t>2020-06-21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xmlns="" id="{9828FDFA-58A1-4A2A-9101-CDCB2627A1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xmlns="" id="{9B7584E1-84F7-40D1-A107-857CDEDF6C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A9362C-50AC-4FD7-949C-9BE5315A804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583484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xmlns="" id="{623AE106-5B20-4CF3-954E-EF8B7D8EEEA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xmlns="" id="{AACF700C-BA71-4030-BE93-7D33C57B55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2594D0-837C-4DBE-89AB-D13A439C0988}" type="datetimeFigureOut">
              <a:rPr lang="ko-KR" altLang="en-US" smtClean="0"/>
              <a:t>2020-06-21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xmlns="" id="{DDC47C81-B506-460F-ACD3-4DC1349AE1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xmlns="" id="{C79A53C8-C76A-4CAC-B3DC-2EFD8258FF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A9362C-50AC-4FD7-949C-9BE5315A804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028425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xmlns="" id="{DB5C3BF4-8608-4B08-8C3C-A7F89A515F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2594D0-837C-4DBE-89AB-D13A439C0988}" type="datetimeFigureOut">
              <a:rPr lang="ko-KR" altLang="en-US" smtClean="0"/>
              <a:t>2020-06-21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xmlns="" id="{49CA3500-89E2-4E79-9717-05E358EF28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xmlns="" id="{14493A34-91B2-476B-8A74-308C04657A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A9362C-50AC-4FD7-949C-9BE5315A804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457940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xmlns="" id="{B013055C-C570-4B17-8A91-67C67679548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xmlns="" id="{97C60848-5CCB-46D4-A6AE-A9711F2B386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xmlns="" id="{46506870-9D49-40C4-8C84-68A7D5CB782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xmlns="" id="{951CF148-F761-4BCC-9E84-91BB417FC5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2594D0-837C-4DBE-89AB-D13A439C0988}" type="datetimeFigureOut">
              <a:rPr lang="ko-KR" altLang="en-US" smtClean="0"/>
              <a:t>2020-06-21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xmlns="" id="{75FDFBC6-6B19-4DC3-AD9C-9C6D3B6189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xmlns="" id="{D02DF5D8-B57F-4419-B226-80C411BB3D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A9362C-50AC-4FD7-949C-9BE5315A804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890947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xmlns="" id="{F0ECFFC9-8BA4-4270-9974-34D4B3CF99A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xmlns="" id="{AA8D57F1-1A9D-4301-8ACF-282602FDDE1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xmlns="" id="{B2E09418-7F48-4EFE-AD0D-4D7115E1529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xmlns="" id="{5AB16B28-71D2-4309-A12E-A04F5E02CE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2594D0-837C-4DBE-89AB-D13A439C0988}" type="datetimeFigureOut">
              <a:rPr lang="ko-KR" altLang="en-US" smtClean="0"/>
              <a:t>2020-06-21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xmlns="" id="{823539C8-1368-4DAC-9500-CB1FB7F7C8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xmlns="" id="{8DD10D1E-070F-499F-BB95-2A4B15F398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A9362C-50AC-4FD7-949C-9BE5315A804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509100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xmlns="" id="{529F6E2A-F3DE-4EA0-BDD6-99F6EC25D0B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xmlns="" id="{135A5686-F68A-4FB2-B6B8-E28B1A69C78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xmlns="" id="{236DA87D-FCBC-4882-96C7-4D7717569F6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2594D0-837C-4DBE-89AB-D13A439C0988}" type="datetimeFigureOut">
              <a:rPr lang="ko-KR" altLang="en-US" smtClean="0"/>
              <a:t>2020-06-21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xmlns="" id="{34282A3B-FE48-48C5-B442-8CFFF162946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xmlns="" id="{DD67A0EE-39FE-45B5-9CF1-BB3FC911F9F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A9362C-50AC-4FD7-949C-9BE5315A804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874240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object 24"/>
          <p:cNvSpPr/>
          <p:nvPr/>
        </p:nvSpPr>
        <p:spPr>
          <a:xfrm>
            <a:off x="7222526" y="1064666"/>
            <a:ext cx="1609041" cy="558991"/>
          </a:xfrm>
          <a:custGeom>
            <a:avLst/>
            <a:gdLst/>
            <a:ahLst/>
            <a:cxnLst/>
            <a:rect l="l" t="t" r="r" b="b"/>
            <a:pathLst>
              <a:path w="1579244" h="548639">
                <a:moveTo>
                  <a:pt x="0" y="0"/>
                </a:moveTo>
                <a:lnTo>
                  <a:pt x="1579244" y="0"/>
                </a:lnTo>
                <a:lnTo>
                  <a:pt x="1579244" y="548639"/>
                </a:lnTo>
                <a:lnTo>
                  <a:pt x="0" y="548639"/>
                </a:lnTo>
                <a:lnTo>
                  <a:pt x="0" y="0"/>
                </a:lnTo>
                <a:close/>
              </a:path>
            </a:pathLst>
          </a:custGeom>
          <a:solidFill>
            <a:srgbClr val="FFFFFF"/>
          </a:solidFill>
        </p:spPr>
        <p:txBody>
          <a:bodyPr wrap="square" lIns="0" tIns="0" rIns="0" bIns="0" rtlCol="0">
            <a:noAutofit/>
          </a:bodyPr>
          <a:lstStyle/>
          <a:p>
            <a:endParaRPr sz="1834"/>
          </a:p>
        </p:txBody>
      </p:sp>
      <p:grpSp>
        <p:nvGrpSpPr>
          <p:cNvPr id="56" name="그룹 55">
            <a:extLst>
              <a:ext uri="{FF2B5EF4-FFF2-40B4-BE49-F238E27FC236}">
                <a16:creationId xmlns:a16="http://schemas.microsoft.com/office/drawing/2014/main" xmlns="" id="{BAFA9CEF-0A08-4C98-B378-9F21F07CA41A}"/>
              </a:ext>
            </a:extLst>
          </p:cNvPr>
          <p:cNvGrpSpPr/>
          <p:nvPr/>
        </p:nvGrpSpPr>
        <p:grpSpPr>
          <a:xfrm>
            <a:off x="3022561" y="770246"/>
            <a:ext cx="6146877" cy="5897749"/>
            <a:chOff x="2850963" y="760721"/>
            <a:chExt cx="6146877" cy="5897749"/>
          </a:xfrm>
        </p:grpSpPr>
        <p:sp>
          <p:nvSpPr>
            <p:cNvPr id="9" name="object 9"/>
            <p:cNvSpPr/>
            <p:nvPr/>
          </p:nvSpPr>
          <p:spPr>
            <a:xfrm>
              <a:off x="3480127" y="3810848"/>
              <a:ext cx="93164" cy="0"/>
            </a:xfrm>
            <a:custGeom>
              <a:avLst/>
              <a:gdLst/>
              <a:ahLst/>
              <a:cxnLst/>
              <a:rect l="l" t="t" r="r" b="b"/>
              <a:pathLst>
                <a:path w="91439">
                  <a:moveTo>
                    <a:pt x="91439" y="0"/>
                  </a:moveTo>
                  <a:lnTo>
                    <a:pt x="0" y="0"/>
                  </a:lnTo>
                </a:path>
              </a:pathLst>
            </a:custGeom>
            <a:ln w="9525">
              <a:solidFill>
                <a:srgbClr val="000000"/>
              </a:solidFill>
            </a:ln>
          </p:spPr>
          <p:txBody>
            <a:bodyPr wrap="square" lIns="0" tIns="0" rIns="0" bIns="0" rtlCol="0">
              <a:noAutofit/>
            </a:bodyPr>
            <a:lstStyle/>
            <a:p>
              <a:endParaRPr sz="1834"/>
            </a:p>
          </p:txBody>
        </p:sp>
        <p:grpSp>
          <p:nvGrpSpPr>
            <p:cNvPr id="55" name="그룹 54">
              <a:extLst>
                <a:ext uri="{FF2B5EF4-FFF2-40B4-BE49-F238E27FC236}">
                  <a16:creationId xmlns:a16="http://schemas.microsoft.com/office/drawing/2014/main" xmlns="" id="{D14BDD16-9D2A-4113-845D-9B892E1CF0A4}"/>
                </a:ext>
              </a:extLst>
            </p:cNvPr>
            <p:cNvGrpSpPr/>
            <p:nvPr/>
          </p:nvGrpSpPr>
          <p:grpSpPr>
            <a:xfrm>
              <a:off x="2850963" y="760721"/>
              <a:ext cx="6146877" cy="5897749"/>
              <a:chOff x="2850963" y="760721"/>
              <a:chExt cx="6146877" cy="5897749"/>
            </a:xfrm>
          </p:grpSpPr>
          <p:sp>
            <p:nvSpPr>
              <p:cNvPr id="10" name="object 10"/>
              <p:cNvSpPr/>
              <p:nvPr/>
            </p:nvSpPr>
            <p:spPr>
              <a:xfrm>
                <a:off x="3480127" y="2857585"/>
                <a:ext cx="93164" cy="0"/>
              </a:xfrm>
              <a:custGeom>
                <a:avLst/>
                <a:gdLst/>
                <a:ahLst/>
                <a:cxnLst/>
                <a:rect l="l" t="t" r="r" b="b"/>
                <a:pathLst>
                  <a:path w="91439">
                    <a:moveTo>
                      <a:pt x="91439" y="0"/>
                    </a:moveTo>
                    <a:lnTo>
                      <a:pt x="0" y="0"/>
                    </a:lnTo>
                  </a:path>
                </a:pathLst>
              </a:custGeom>
              <a:ln w="9525">
                <a:solidFill>
                  <a:srgbClr val="000000"/>
                </a:solidFill>
              </a:ln>
            </p:spPr>
            <p:txBody>
              <a:bodyPr wrap="square" lIns="0" tIns="0" rIns="0" bIns="0" rtlCol="0">
                <a:noAutofit/>
              </a:bodyPr>
              <a:lstStyle/>
              <a:p>
                <a:endParaRPr sz="1834"/>
              </a:p>
            </p:txBody>
          </p:sp>
          <p:sp>
            <p:nvSpPr>
              <p:cNvPr id="11" name="object 11"/>
              <p:cNvSpPr/>
              <p:nvPr/>
            </p:nvSpPr>
            <p:spPr>
              <a:xfrm>
                <a:off x="3480127" y="1904453"/>
                <a:ext cx="93164" cy="0"/>
              </a:xfrm>
              <a:custGeom>
                <a:avLst/>
                <a:gdLst/>
                <a:ahLst/>
                <a:cxnLst/>
                <a:rect l="l" t="t" r="r" b="b"/>
                <a:pathLst>
                  <a:path w="91439">
                    <a:moveTo>
                      <a:pt x="91439" y="0"/>
                    </a:moveTo>
                    <a:lnTo>
                      <a:pt x="0" y="0"/>
                    </a:lnTo>
                  </a:path>
                </a:pathLst>
              </a:custGeom>
              <a:ln w="9525">
                <a:solidFill>
                  <a:srgbClr val="000000"/>
                </a:solidFill>
              </a:ln>
            </p:spPr>
            <p:txBody>
              <a:bodyPr wrap="square" lIns="0" tIns="0" rIns="0" bIns="0" rtlCol="0">
                <a:noAutofit/>
              </a:bodyPr>
              <a:lstStyle/>
              <a:p>
                <a:endParaRPr sz="1834"/>
              </a:p>
            </p:txBody>
          </p:sp>
          <p:grpSp>
            <p:nvGrpSpPr>
              <p:cNvPr id="54" name="그룹 53">
                <a:extLst>
                  <a:ext uri="{FF2B5EF4-FFF2-40B4-BE49-F238E27FC236}">
                    <a16:creationId xmlns:a16="http://schemas.microsoft.com/office/drawing/2014/main" xmlns="" id="{57E2C14B-59B4-411F-A869-45176D575679}"/>
                  </a:ext>
                </a:extLst>
              </p:cNvPr>
              <p:cNvGrpSpPr/>
              <p:nvPr/>
            </p:nvGrpSpPr>
            <p:grpSpPr>
              <a:xfrm>
                <a:off x="2850963" y="760721"/>
                <a:ext cx="6146877" cy="5897749"/>
                <a:chOff x="2850963" y="760721"/>
                <a:chExt cx="6146877" cy="5897749"/>
              </a:xfrm>
            </p:grpSpPr>
            <p:sp>
              <p:nvSpPr>
                <p:cNvPr id="7" name="object 7"/>
                <p:cNvSpPr/>
                <p:nvPr/>
              </p:nvSpPr>
              <p:spPr>
                <a:xfrm>
                  <a:off x="3480127" y="5717112"/>
                  <a:ext cx="93164" cy="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91439">
                      <a:moveTo>
                        <a:pt x="91439" y="0"/>
                      </a:moveTo>
                      <a:lnTo>
                        <a:pt x="0" y="0"/>
                      </a:lnTo>
                    </a:path>
                  </a:pathLst>
                </a:custGeom>
                <a:ln w="9525">
                  <a:solidFill>
                    <a:srgbClr val="000000"/>
                  </a:solidFill>
                </a:ln>
              </p:spPr>
              <p:txBody>
                <a:bodyPr wrap="square" lIns="0" tIns="0" rIns="0" bIns="0" rtlCol="0">
                  <a:noAutofit/>
                </a:bodyPr>
                <a:lstStyle/>
                <a:p>
                  <a:endParaRPr sz="1834"/>
                </a:p>
              </p:txBody>
            </p:sp>
            <p:sp>
              <p:nvSpPr>
                <p:cNvPr id="8" name="object 8"/>
                <p:cNvSpPr/>
                <p:nvPr/>
              </p:nvSpPr>
              <p:spPr>
                <a:xfrm>
                  <a:off x="3480127" y="4763981"/>
                  <a:ext cx="93164" cy="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91439">
                      <a:moveTo>
                        <a:pt x="91439" y="0"/>
                      </a:moveTo>
                      <a:lnTo>
                        <a:pt x="0" y="0"/>
                      </a:lnTo>
                    </a:path>
                  </a:pathLst>
                </a:custGeom>
                <a:ln w="9525">
                  <a:solidFill>
                    <a:srgbClr val="000000"/>
                  </a:solidFill>
                </a:ln>
              </p:spPr>
              <p:txBody>
                <a:bodyPr wrap="square" lIns="0" tIns="0" rIns="0" bIns="0" rtlCol="0">
                  <a:noAutofit/>
                </a:bodyPr>
                <a:lstStyle/>
                <a:p>
                  <a:endParaRPr sz="1834"/>
                </a:p>
              </p:txBody>
            </p:sp>
            <p:sp>
              <p:nvSpPr>
                <p:cNvPr id="12" name="object 12"/>
                <p:cNvSpPr/>
                <p:nvPr/>
              </p:nvSpPr>
              <p:spPr>
                <a:xfrm>
                  <a:off x="3480127" y="951320"/>
                  <a:ext cx="93164" cy="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91439">
                      <a:moveTo>
                        <a:pt x="91439" y="0"/>
                      </a:moveTo>
                      <a:lnTo>
                        <a:pt x="0" y="0"/>
                      </a:lnTo>
                    </a:path>
                  </a:pathLst>
                </a:custGeom>
                <a:ln w="9525">
                  <a:solidFill>
                    <a:srgbClr val="000000"/>
                  </a:solidFill>
                </a:ln>
              </p:spPr>
              <p:txBody>
                <a:bodyPr wrap="square" lIns="0" tIns="0" rIns="0" bIns="0" rtlCol="0">
                  <a:noAutofit/>
                </a:bodyPr>
                <a:lstStyle/>
                <a:p>
                  <a:endParaRPr sz="1834"/>
                </a:p>
              </p:txBody>
            </p:sp>
            <p:grpSp>
              <p:nvGrpSpPr>
                <p:cNvPr id="30" name="그룹 29">
                  <a:extLst>
                    <a:ext uri="{FF2B5EF4-FFF2-40B4-BE49-F238E27FC236}">
                      <a16:creationId xmlns:a16="http://schemas.microsoft.com/office/drawing/2014/main" xmlns="" id="{F7F14790-2CA3-416C-9D84-2BD1464152FC}"/>
                    </a:ext>
                  </a:extLst>
                </p:cNvPr>
                <p:cNvGrpSpPr/>
                <p:nvPr/>
              </p:nvGrpSpPr>
              <p:grpSpPr>
                <a:xfrm>
                  <a:off x="2850963" y="760721"/>
                  <a:ext cx="6146877" cy="5897749"/>
                  <a:chOff x="2850963" y="760721"/>
                  <a:chExt cx="6146877" cy="5897749"/>
                </a:xfrm>
              </p:grpSpPr>
              <p:sp>
                <p:nvSpPr>
                  <p:cNvPr id="2" name="object 2"/>
                  <p:cNvSpPr txBox="1"/>
                  <p:nvPr/>
                </p:nvSpPr>
                <p:spPr>
                  <a:xfrm>
                    <a:off x="3718086" y="6087834"/>
                    <a:ext cx="112574" cy="197976"/>
                  </a:xfrm>
                  <a:prstGeom prst="rect">
                    <a:avLst/>
                  </a:prstGeom>
                </p:spPr>
                <p:txBody>
                  <a:bodyPr vert="horz" wrap="square" lIns="0" tIns="0" rIns="0" bIns="0" rtlCol="0">
                    <a:noAutofit/>
                  </a:bodyPr>
                  <a:lstStyle/>
                  <a:p>
                    <a:pPr marL="12940"/>
                    <a:r>
                      <a:rPr sz="1223" dirty="0">
                        <a:latin typeface="Arial"/>
                        <a:cs typeface="Arial"/>
                      </a:rPr>
                      <a:t>0</a:t>
                    </a:r>
                    <a:endParaRPr sz="1223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3" name="object 3"/>
                  <p:cNvSpPr txBox="1"/>
                  <p:nvPr/>
                </p:nvSpPr>
                <p:spPr>
                  <a:xfrm>
                    <a:off x="5152184" y="6087834"/>
                    <a:ext cx="198623" cy="197976"/>
                  </a:xfrm>
                  <a:prstGeom prst="rect">
                    <a:avLst/>
                  </a:prstGeom>
                </p:spPr>
                <p:txBody>
                  <a:bodyPr vert="horz" wrap="square" lIns="0" tIns="0" rIns="0" bIns="0" rtlCol="0">
                    <a:noAutofit/>
                  </a:bodyPr>
                  <a:lstStyle/>
                  <a:p>
                    <a:pPr marL="12940"/>
                    <a:r>
                      <a:rPr sz="1223" dirty="0">
                        <a:latin typeface="Arial"/>
                        <a:cs typeface="Arial"/>
                      </a:rPr>
                      <a:t>50</a:t>
                    </a:r>
                    <a:endParaRPr sz="1223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4" name="object 4"/>
                  <p:cNvSpPr txBox="1"/>
                  <p:nvPr/>
                </p:nvSpPr>
                <p:spPr>
                  <a:xfrm>
                    <a:off x="6586283" y="6087834"/>
                    <a:ext cx="285319" cy="197976"/>
                  </a:xfrm>
                  <a:prstGeom prst="rect">
                    <a:avLst/>
                  </a:prstGeom>
                </p:spPr>
                <p:txBody>
                  <a:bodyPr vert="horz" wrap="square" lIns="0" tIns="0" rIns="0" bIns="0" rtlCol="0">
                    <a:noAutofit/>
                  </a:bodyPr>
                  <a:lstStyle/>
                  <a:p>
                    <a:pPr marL="12940"/>
                    <a:r>
                      <a:rPr sz="1223" dirty="0">
                        <a:latin typeface="Arial"/>
                        <a:cs typeface="Arial"/>
                      </a:rPr>
                      <a:t>100</a:t>
                    </a:r>
                    <a:endParaRPr sz="1223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5" name="object 5"/>
                  <p:cNvSpPr txBox="1"/>
                  <p:nvPr/>
                </p:nvSpPr>
                <p:spPr>
                  <a:xfrm>
                    <a:off x="8063598" y="6087834"/>
                    <a:ext cx="285319" cy="197976"/>
                  </a:xfrm>
                  <a:prstGeom prst="rect">
                    <a:avLst/>
                  </a:prstGeom>
                </p:spPr>
                <p:txBody>
                  <a:bodyPr vert="horz" wrap="square" lIns="0" tIns="0" rIns="0" bIns="0" rtlCol="0">
                    <a:noAutofit/>
                  </a:bodyPr>
                  <a:lstStyle/>
                  <a:p>
                    <a:pPr marL="12940"/>
                    <a:r>
                      <a:rPr sz="1223" dirty="0">
                        <a:latin typeface="Arial"/>
                        <a:cs typeface="Arial"/>
                      </a:rPr>
                      <a:t>150</a:t>
                    </a:r>
                    <a:endParaRPr sz="1223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13" name="object 13"/>
                  <p:cNvSpPr txBox="1"/>
                  <p:nvPr/>
                </p:nvSpPr>
                <p:spPr>
                  <a:xfrm>
                    <a:off x="3194419" y="5596256"/>
                    <a:ext cx="197976" cy="241971"/>
                  </a:xfrm>
                  <a:prstGeom prst="rect">
                    <a:avLst/>
                  </a:prstGeom>
                </p:spPr>
                <p:txBody>
                  <a:bodyPr vert="vert270" wrap="square" lIns="0" tIns="0" rIns="0" bIns="0" rtlCol="0">
                    <a:noAutofit/>
                  </a:bodyPr>
                  <a:lstStyle/>
                  <a:p>
                    <a:pPr marL="12940"/>
                    <a:r>
                      <a:rPr sz="1223" dirty="0">
                        <a:latin typeface="Arial"/>
                        <a:cs typeface="Arial"/>
                      </a:rPr>
                      <a:t>0.0</a:t>
                    </a:r>
                    <a:endParaRPr sz="1223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14" name="object 14"/>
                  <p:cNvSpPr txBox="1"/>
                  <p:nvPr/>
                </p:nvSpPr>
                <p:spPr>
                  <a:xfrm>
                    <a:off x="3194419" y="4643124"/>
                    <a:ext cx="197976" cy="241971"/>
                  </a:xfrm>
                  <a:prstGeom prst="rect">
                    <a:avLst/>
                  </a:prstGeom>
                </p:spPr>
                <p:txBody>
                  <a:bodyPr vert="vert270" wrap="square" lIns="0" tIns="0" rIns="0" bIns="0" rtlCol="0">
                    <a:noAutofit/>
                  </a:bodyPr>
                  <a:lstStyle/>
                  <a:p>
                    <a:pPr marL="12940"/>
                    <a:r>
                      <a:rPr sz="1223" dirty="0">
                        <a:latin typeface="Arial"/>
                        <a:cs typeface="Arial"/>
                      </a:rPr>
                      <a:t>0.2</a:t>
                    </a:r>
                    <a:endParaRPr sz="1223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15" name="object 15"/>
                  <p:cNvSpPr txBox="1"/>
                  <p:nvPr/>
                </p:nvSpPr>
                <p:spPr>
                  <a:xfrm>
                    <a:off x="3194419" y="3689992"/>
                    <a:ext cx="197976" cy="241971"/>
                  </a:xfrm>
                  <a:prstGeom prst="rect">
                    <a:avLst/>
                  </a:prstGeom>
                </p:spPr>
                <p:txBody>
                  <a:bodyPr vert="vert270" wrap="square" lIns="0" tIns="0" rIns="0" bIns="0" rtlCol="0">
                    <a:noAutofit/>
                  </a:bodyPr>
                  <a:lstStyle/>
                  <a:p>
                    <a:pPr marL="12940"/>
                    <a:r>
                      <a:rPr sz="1223" dirty="0">
                        <a:latin typeface="Arial"/>
                        <a:cs typeface="Arial"/>
                      </a:rPr>
                      <a:t>0.4</a:t>
                    </a:r>
                    <a:endParaRPr sz="1223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16" name="object 16"/>
                  <p:cNvSpPr txBox="1"/>
                  <p:nvPr/>
                </p:nvSpPr>
                <p:spPr>
                  <a:xfrm>
                    <a:off x="3194419" y="2736730"/>
                    <a:ext cx="197976" cy="241971"/>
                  </a:xfrm>
                  <a:prstGeom prst="rect">
                    <a:avLst/>
                  </a:prstGeom>
                </p:spPr>
                <p:txBody>
                  <a:bodyPr vert="vert270" wrap="square" lIns="0" tIns="0" rIns="0" bIns="0" rtlCol="0">
                    <a:noAutofit/>
                  </a:bodyPr>
                  <a:lstStyle/>
                  <a:p>
                    <a:pPr marL="12940"/>
                    <a:r>
                      <a:rPr sz="1223" dirty="0">
                        <a:latin typeface="Arial"/>
                        <a:cs typeface="Arial"/>
                      </a:rPr>
                      <a:t>0.6</a:t>
                    </a:r>
                    <a:endParaRPr sz="1223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17" name="object 17"/>
                  <p:cNvSpPr txBox="1"/>
                  <p:nvPr/>
                </p:nvSpPr>
                <p:spPr>
                  <a:xfrm>
                    <a:off x="3194419" y="1783597"/>
                    <a:ext cx="197976" cy="241971"/>
                  </a:xfrm>
                  <a:prstGeom prst="rect">
                    <a:avLst/>
                  </a:prstGeom>
                </p:spPr>
                <p:txBody>
                  <a:bodyPr vert="vert270" wrap="square" lIns="0" tIns="0" rIns="0" bIns="0" rtlCol="0">
                    <a:noAutofit/>
                  </a:bodyPr>
                  <a:lstStyle/>
                  <a:p>
                    <a:pPr marL="12940"/>
                    <a:r>
                      <a:rPr sz="1223" dirty="0">
                        <a:latin typeface="Arial"/>
                        <a:cs typeface="Arial"/>
                      </a:rPr>
                      <a:t>0.8</a:t>
                    </a:r>
                    <a:endParaRPr sz="1223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18" name="object 18"/>
                  <p:cNvSpPr txBox="1"/>
                  <p:nvPr/>
                </p:nvSpPr>
                <p:spPr>
                  <a:xfrm>
                    <a:off x="3194419" y="830465"/>
                    <a:ext cx="197976" cy="241971"/>
                  </a:xfrm>
                  <a:prstGeom prst="rect">
                    <a:avLst/>
                  </a:prstGeom>
                </p:spPr>
                <p:txBody>
                  <a:bodyPr vert="vert270" wrap="square" lIns="0" tIns="0" rIns="0" bIns="0" rtlCol="0">
                    <a:noAutofit/>
                  </a:bodyPr>
                  <a:lstStyle/>
                  <a:p>
                    <a:pPr marL="12940"/>
                    <a:r>
                      <a:rPr sz="1223" dirty="0">
                        <a:latin typeface="Arial"/>
                        <a:cs typeface="Arial"/>
                      </a:rPr>
                      <a:t>1.0</a:t>
                    </a:r>
                    <a:endParaRPr sz="1223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19" name="object 19"/>
                  <p:cNvSpPr/>
                  <p:nvPr/>
                </p:nvSpPr>
                <p:spPr>
                  <a:xfrm>
                    <a:off x="3573291" y="760721"/>
                    <a:ext cx="5424549" cy="5146994"/>
                  </a:xfrm>
                  <a:custGeom>
                    <a:avLst/>
                    <a:gdLst/>
                    <a:ahLst/>
                    <a:cxnLst/>
                    <a:rect l="l" t="t" r="r" b="b"/>
                    <a:pathLst>
                      <a:path w="5324094" h="5051679">
                        <a:moveTo>
                          <a:pt x="0" y="5051679"/>
                        </a:moveTo>
                        <a:lnTo>
                          <a:pt x="5324094" y="5051679"/>
                        </a:lnTo>
                        <a:lnTo>
                          <a:pt x="5324094" y="0"/>
                        </a:lnTo>
                        <a:lnTo>
                          <a:pt x="0" y="0"/>
                        </a:lnTo>
                        <a:lnTo>
                          <a:pt x="0" y="5051679"/>
                        </a:lnTo>
                      </a:path>
                    </a:pathLst>
                  </a:custGeom>
                  <a:ln w="9524">
                    <a:solidFill>
                      <a:srgbClr val="000000"/>
                    </a:solidFill>
                  </a:ln>
                </p:spPr>
                <p:txBody>
                  <a:bodyPr wrap="square" lIns="0" tIns="0" rIns="0" bIns="0" rtlCol="0">
                    <a:noAutofit/>
                  </a:bodyPr>
                  <a:lstStyle/>
                  <a:p>
                    <a:endParaRPr sz="1834"/>
                  </a:p>
                </p:txBody>
              </p:sp>
              <p:sp>
                <p:nvSpPr>
                  <p:cNvPr id="20" name="object 20"/>
                  <p:cNvSpPr txBox="1"/>
                  <p:nvPr/>
                </p:nvSpPr>
                <p:spPr>
                  <a:xfrm>
                    <a:off x="5793859" y="6460494"/>
                    <a:ext cx="984058" cy="197976"/>
                  </a:xfrm>
                  <a:prstGeom prst="rect">
                    <a:avLst/>
                  </a:prstGeom>
                </p:spPr>
                <p:txBody>
                  <a:bodyPr vert="horz" wrap="square" lIns="0" tIns="0" rIns="0" bIns="0" rtlCol="0">
                    <a:noAutofit/>
                  </a:bodyPr>
                  <a:lstStyle/>
                  <a:p>
                    <a:pPr marL="12940"/>
                    <a:r>
                      <a:rPr sz="1223" dirty="0">
                        <a:latin typeface="Arial"/>
                        <a:cs typeface="Arial"/>
                      </a:rPr>
                      <a:t>Time(months)</a:t>
                    </a:r>
                    <a:endParaRPr sz="1223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21" name="object 21"/>
                  <p:cNvSpPr txBox="1"/>
                  <p:nvPr/>
                </p:nvSpPr>
                <p:spPr>
                  <a:xfrm>
                    <a:off x="2850963" y="2025568"/>
                    <a:ext cx="197916" cy="2541761"/>
                  </a:xfrm>
                  <a:prstGeom prst="rect">
                    <a:avLst/>
                  </a:prstGeom>
                </p:spPr>
                <p:txBody>
                  <a:bodyPr vert="vert270" wrap="square" lIns="0" tIns="0" rIns="0" bIns="0" rtlCol="0">
                    <a:noAutofit/>
                  </a:bodyPr>
                  <a:lstStyle/>
                  <a:p>
                    <a:pPr marL="12940"/>
                    <a:r>
                      <a:rPr sz="1223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ancer specific</a:t>
                    </a:r>
                    <a:r>
                      <a:rPr lang="en-US" altLang="ko-KR" sz="1223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</a:t>
                    </a:r>
                    <a:r>
                      <a:rPr lang="ko-KR" altLang="en-US" sz="1223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</a:t>
                    </a:r>
                    <a:r>
                      <a:rPr lang="en-US" altLang="ko-KR" sz="1223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urvival (Probability)</a:t>
                    </a:r>
                    <a:endParaRPr sz="1223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2" name="object 22"/>
                  <p:cNvSpPr/>
                  <p:nvPr/>
                </p:nvSpPr>
                <p:spPr>
                  <a:xfrm>
                    <a:off x="3774243" y="951320"/>
                    <a:ext cx="5022773" cy="1266530"/>
                  </a:xfrm>
                  <a:custGeom>
                    <a:avLst/>
                    <a:gdLst/>
                    <a:ahLst/>
                    <a:cxnLst/>
                    <a:rect l="l" t="t" r="r" b="b"/>
                    <a:pathLst>
                      <a:path w="4929759" h="1243076">
                        <a:moveTo>
                          <a:pt x="0" y="0"/>
                        </a:moveTo>
                        <a:lnTo>
                          <a:pt x="23114" y="0"/>
                        </a:lnTo>
                        <a:lnTo>
                          <a:pt x="23114" y="24765"/>
                        </a:lnTo>
                        <a:lnTo>
                          <a:pt x="272542" y="24765"/>
                        </a:lnTo>
                        <a:lnTo>
                          <a:pt x="272542" y="51181"/>
                        </a:lnTo>
                        <a:lnTo>
                          <a:pt x="321818" y="51181"/>
                        </a:lnTo>
                        <a:lnTo>
                          <a:pt x="321818" y="77850"/>
                        </a:lnTo>
                        <a:lnTo>
                          <a:pt x="359537" y="77850"/>
                        </a:lnTo>
                        <a:lnTo>
                          <a:pt x="359537" y="104521"/>
                        </a:lnTo>
                        <a:lnTo>
                          <a:pt x="426212" y="104521"/>
                        </a:lnTo>
                        <a:lnTo>
                          <a:pt x="426212" y="131445"/>
                        </a:lnTo>
                        <a:lnTo>
                          <a:pt x="507365" y="131445"/>
                        </a:lnTo>
                        <a:lnTo>
                          <a:pt x="507365" y="158623"/>
                        </a:lnTo>
                        <a:lnTo>
                          <a:pt x="530606" y="158623"/>
                        </a:lnTo>
                        <a:lnTo>
                          <a:pt x="530606" y="185928"/>
                        </a:lnTo>
                        <a:lnTo>
                          <a:pt x="623443" y="185928"/>
                        </a:lnTo>
                        <a:lnTo>
                          <a:pt x="623443" y="213613"/>
                        </a:lnTo>
                        <a:lnTo>
                          <a:pt x="629158" y="213613"/>
                        </a:lnTo>
                        <a:lnTo>
                          <a:pt x="629158" y="241300"/>
                        </a:lnTo>
                        <a:lnTo>
                          <a:pt x="649478" y="241300"/>
                        </a:lnTo>
                        <a:lnTo>
                          <a:pt x="649478" y="297180"/>
                        </a:lnTo>
                        <a:lnTo>
                          <a:pt x="666877" y="297180"/>
                        </a:lnTo>
                        <a:lnTo>
                          <a:pt x="666877" y="324993"/>
                        </a:lnTo>
                        <a:lnTo>
                          <a:pt x="690118" y="324993"/>
                        </a:lnTo>
                        <a:lnTo>
                          <a:pt x="690118" y="353060"/>
                        </a:lnTo>
                        <a:lnTo>
                          <a:pt x="739394" y="353060"/>
                        </a:lnTo>
                        <a:lnTo>
                          <a:pt x="739394" y="381762"/>
                        </a:lnTo>
                        <a:lnTo>
                          <a:pt x="794512" y="381762"/>
                        </a:lnTo>
                        <a:lnTo>
                          <a:pt x="794512" y="410591"/>
                        </a:lnTo>
                        <a:lnTo>
                          <a:pt x="806069" y="410591"/>
                        </a:lnTo>
                        <a:lnTo>
                          <a:pt x="806069" y="439674"/>
                        </a:lnTo>
                        <a:lnTo>
                          <a:pt x="852551" y="439674"/>
                        </a:lnTo>
                        <a:lnTo>
                          <a:pt x="852551" y="468630"/>
                        </a:lnTo>
                        <a:lnTo>
                          <a:pt x="913384" y="468630"/>
                        </a:lnTo>
                        <a:lnTo>
                          <a:pt x="913384" y="498729"/>
                        </a:lnTo>
                        <a:lnTo>
                          <a:pt x="924941" y="498729"/>
                        </a:lnTo>
                        <a:lnTo>
                          <a:pt x="924941" y="528828"/>
                        </a:lnTo>
                        <a:lnTo>
                          <a:pt x="1041019" y="528828"/>
                        </a:lnTo>
                        <a:lnTo>
                          <a:pt x="1041019" y="560451"/>
                        </a:lnTo>
                        <a:lnTo>
                          <a:pt x="1069975" y="560451"/>
                        </a:lnTo>
                        <a:lnTo>
                          <a:pt x="1069975" y="592074"/>
                        </a:lnTo>
                        <a:lnTo>
                          <a:pt x="1206246" y="592074"/>
                        </a:lnTo>
                        <a:lnTo>
                          <a:pt x="1206246" y="624840"/>
                        </a:lnTo>
                        <a:lnTo>
                          <a:pt x="1330960" y="624840"/>
                        </a:lnTo>
                        <a:lnTo>
                          <a:pt x="1330960" y="660019"/>
                        </a:lnTo>
                        <a:lnTo>
                          <a:pt x="1420876" y="660019"/>
                        </a:lnTo>
                        <a:lnTo>
                          <a:pt x="1420876" y="696849"/>
                        </a:lnTo>
                        <a:lnTo>
                          <a:pt x="1452753" y="696849"/>
                        </a:lnTo>
                        <a:lnTo>
                          <a:pt x="1452753" y="734822"/>
                        </a:lnTo>
                        <a:lnTo>
                          <a:pt x="1542669" y="734822"/>
                        </a:lnTo>
                        <a:lnTo>
                          <a:pt x="1542669" y="774192"/>
                        </a:lnTo>
                        <a:lnTo>
                          <a:pt x="1658620" y="774192"/>
                        </a:lnTo>
                        <a:lnTo>
                          <a:pt x="1658620" y="816610"/>
                        </a:lnTo>
                        <a:lnTo>
                          <a:pt x="1661541" y="816610"/>
                        </a:lnTo>
                        <a:lnTo>
                          <a:pt x="1661541" y="859028"/>
                        </a:lnTo>
                        <a:lnTo>
                          <a:pt x="1690497" y="859028"/>
                        </a:lnTo>
                        <a:lnTo>
                          <a:pt x="1690497" y="902462"/>
                        </a:lnTo>
                        <a:lnTo>
                          <a:pt x="1699260" y="902462"/>
                        </a:lnTo>
                        <a:lnTo>
                          <a:pt x="1699260" y="989203"/>
                        </a:lnTo>
                        <a:lnTo>
                          <a:pt x="1919605" y="989203"/>
                        </a:lnTo>
                        <a:lnTo>
                          <a:pt x="1919605" y="1036574"/>
                        </a:lnTo>
                        <a:lnTo>
                          <a:pt x="2154555" y="1036574"/>
                        </a:lnTo>
                        <a:lnTo>
                          <a:pt x="2154555" y="1091692"/>
                        </a:lnTo>
                        <a:lnTo>
                          <a:pt x="2224151" y="1091692"/>
                        </a:lnTo>
                        <a:lnTo>
                          <a:pt x="2224151" y="1147699"/>
                        </a:lnTo>
                        <a:lnTo>
                          <a:pt x="2754757" y="1147699"/>
                        </a:lnTo>
                        <a:lnTo>
                          <a:pt x="2754757" y="1243076"/>
                        </a:lnTo>
                        <a:lnTo>
                          <a:pt x="4929759" y="1243076"/>
                        </a:lnTo>
                      </a:path>
                    </a:pathLst>
                  </a:custGeom>
                  <a:ln w="19050">
                    <a:solidFill>
                      <a:srgbClr val="00008B"/>
                    </a:solidFill>
                  </a:ln>
                </p:spPr>
                <p:txBody>
                  <a:bodyPr wrap="square" lIns="0" tIns="0" rIns="0" bIns="0" rtlCol="0">
                    <a:noAutofit/>
                  </a:bodyPr>
                  <a:lstStyle/>
                  <a:p>
                    <a:endParaRPr sz="1834"/>
                  </a:p>
                </p:txBody>
              </p:sp>
              <p:sp>
                <p:nvSpPr>
                  <p:cNvPr id="23" name="object 23"/>
                  <p:cNvSpPr/>
                  <p:nvPr/>
                </p:nvSpPr>
                <p:spPr>
                  <a:xfrm>
                    <a:off x="3774242" y="951320"/>
                    <a:ext cx="3746280" cy="2383996"/>
                  </a:xfrm>
                  <a:custGeom>
                    <a:avLst/>
                    <a:gdLst/>
                    <a:ahLst/>
                    <a:cxnLst/>
                    <a:rect l="l" t="t" r="r" b="b"/>
                    <a:pathLst>
                      <a:path w="3676904" h="2339848">
                        <a:moveTo>
                          <a:pt x="0" y="0"/>
                        </a:moveTo>
                        <a:lnTo>
                          <a:pt x="75311" y="0"/>
                        </a:lnTo>
                        <a:lnTo>
                          <a:pt x="75311" y="102870"/>
                        </a:lnTo>
                        <a:lnTo>
                          <a:pt x="101473" y="102870"/>
                        </a:lnTo>
                        <a:lnTo>
                          <a:pt x="101473" y="154178"/>
                        </a:lnTo>
                        <a:lnTo>
                          <a:pt x="147828" y="154178"/>
                        </a:lnTo>
                        <a:lnTo>
                          <a:pt x="147828" y="205612"/>
                        </a:lnTo>
                        <a:lnTo>
                          <a:pt x="234823" y="205612"/>
                        </a:lnTo>
                        <a:lnTo>
                          <a:pt x="234823" y="258825"/>
                        </a:lnTo>
                        <a:lnTo>
                          <a:pt x="304419" y="258825"/>
                        </a:lnTo>
                        <a:lnTo>
                          <a:pt x="304419" y="312166"/>
                        </a:lnTo>
                        <a:lnTo>
                          <a:pt x="437769" y="312166"/>
                        </a:lnTo>
                        <a:lnTo>
                          <a:pt x="437769" y="369570"/>
                        </a:lnTo>
                        <a:lnTo>
                          <a:pt x="452374" y="369570"/>
                        </a:lnTo>
                        <a:lnTo>
                          <a:pt x="452374" y="426974"/>
                        </a:lnTo>
                        <a:lnTo>
                          <a:pt x="487172" y="426974"/>
                        </a:lnTo>
                        <a:lnTo>
                          <a:pt x="487172" y="543433"/>
                        </a:lnTo>
                        <a:lnTo>
                          <a:pt x="504571" y="543433"/>
                        </a:lnTo>
                        <a:lnTo>
                          <a:pt x="504571" y="601726"/>
                        </a:lnTo>
                        <a:lnTo>
                          <a:pt x="620522" y="601726"/>
                        </a:lnTo>
                        <a:lnTo>
                          <a:pt x="620522" y="662559"/>
                        </a:lnTo>
                        <a:lnTo>
                          <a:pt x="637921" y="662559"/>
                        </a:lnTo>
                        <a:lnTo>
                          <a:pt x="637921" y="724281"/>
                        </a:lnTo>
                        <a:lnTo>
                          <a:pt x="678561" y="724281"/>
                        </a:lnTo>
                        <a:lnTo>
                          <a:pt x="678561" y="786003"/>
                        </a:lnTo>
                        <a:lnTo>
                          <a:pt x="687197" y="786003"/>
                        </a:lnTo>
                        <a:lnTo>
                          <a:pt x="687197" y="847851"/>
                        </a:lnTo>
                        <a:lnTo>
                          <a:pt x="701675" y="847851"/>
                        </a:lnTo>
                        <a:lnTo>
                          <a:pt x="701675" y="910590"/>
                        </a:lnTo>
                        <a:lnTo>
                          <a:pt x="806069" y="910590"/>
                        </a:lnTo>
                        <a:lnTo>
                          <a:pt x="806069" y="974471"/>
                        </a:lnTo>
                        <a:lnTo>
                          <a:pt x="835152" y="974471"/>
                        </a:lnTo>
                        <a:lnTo>
                          <a:pt x="835152" y="1038225"/>
                        </a:lnTo>
                        <a:lnTo>
                          <a:pt x="864108" y="1038225"/>
                        </a:lnTo>
                        <a:lnTo>
                          <a:pt x="864108" y="1102106"/>
                        </a:lnTo>
                        <a:lnTo>
                          <a:pt x="991743" y="1102106"/>
                        </a:lnTo>
                        <a:lnTo>
                          <a:pt x="991743" y="1168400"/>
                        </a:lnTo>
                        <a:lnTo>
                          <a:pt x="1041019" y="1168400"/>
                        </a:lnTo>
                        <a:lnTo>
                          <a:pt x="1041019" y="1234567"/>
                        </a:lnTo>
                        <a:lnTo>
                          <a:pt x="1171448" y="1234567"/>
                        </a:lnTo>
                        <a:lnTo>
                          <a:pt x="1171448" y="1303401"/>
                        </a:lnTo>
                        <a:lnTo>
                          <a:pt x="1333881" y="1303401"/>
                        </a:lnTo>
                        <a:lnTo>
                          <a:pt x="1333881" y="1380109"/>
                        </a:lnTo>
                        <a:lnTo>
                          <a:pt x="1435354" y="1380109"/>
                        </a:lnTo>
                        <a:lnTo>
                          <a:pt x="1435354" y="1466850"/>
                        </a:lnTo>
                        <a:lnTo>
                          <a:pt x="1467231" y="1466850"/>
                        </a:lnTo>
                        <a:lnTo>
                          <a:pt x="1467231" y="1558544"/>
                        </a:lnTo>
                        <a:lnTo>
                          <a:pt x="1554226" y="1558544"/>
                        </a:lnTo>
                        <a:lnTo>
                          <a:pt x="1554226" y="1653159"/>
                        </a:lnTo>
                        <a:lnTo>
                          <a:pt x="1887728" y="1653159"/>
                        </a:lnTo>
                        <a:lnTo>
                          <a:pt x="1887728" y="1765173"/>
                        </a:lnTo>
                        <a:lnTo>
                          <a:pt x="1971802" y="1765173"/>
                        </a:lnTo>
                        <a:lnTo>
                          <a:pt x="1971802" y="1891792"/>
                        </a:lnTo>
                        <a:lnTo>
                          <a:pt x="2490851" y="1891792"/>
                        </a:lnTo>
                        <a:lnTo>
                          <a:pt x="2490851" y="2106041"/>
                        </a:lnTo>
                        <a:lnTo>
                          <a:pt x="2589530" y="2106041"/>
                        </a:lnTo>
                        <a:lnTo>
                          <a:pt x="2589530" y="2339848"/>
                        </a:lnTo>
                        <a:lnTo>
                          <a:pt x="3676904" y="2339848"/>
                        </a:lnTo>
                      </a:path>
                    </a:pathLst>
                  </a:custGeom>
                  <a:ln w="19050">
                    <a:solidFill>
                      <a:srgbClr val="FFA500"/>
                    </a:solidFill>
                  </a:ln>
                </p:spPr>
                <p:txBody>
                  <a:bodyPr wrap="square" lIns="0" tIns="0" rIns="0" bIns="0" rtlCol="0">
                    <a:noAutofit/>
                  </a:bodyPr>
                  <a:lstStyle/>
                  <a:p>
                    <a:endParaRPr sz="1834"/>
                  </a:p>
                </p:txBody>
              </p:sp>
              <p:sp>
                <p:nvSpPr>
                  <p:cNvPr id="26" name="object 26"/>
                  <p:cNvSpPr/>
                  <p:nvPr/>
                </p:nvSpPr>
                <p:spPr>
                  <a:xfrm>
                    <a:off x="7528545" y="947051"/>
                    <a:ext cx="279496" cy="0"/>
                  </a:xfrm>
                  <a:custGeom>
                    <a:avLst/>
                    <a:gdLst/>
                    <a:ahLst/>
                    <a:cxnLst/>
                    <a:rect l="l" t="t" r="r" b="b"/>
                    <a:pathLst>
                      <a:path w="274320">
                        <a:moveTo>
                          <a:pt x="0" y="0"/>
                        </a:moveTo>
                        <a:lnTo>
                          <a:pt x="274320" y="0"/>
                        </a:lnTo>
                      </a:path>
                    </a:pathLst>
                  </a:custGeom>
                  <a:ln w="19050">
                    <a:solidFill>
                      <a:srgbClr val="00008B"/>
                    </a:solidFill>
                  </a:ln>
                </p:spPr>
                <p:txBody>
                  <a:bodyPr wrap="square" lIns="0" tIns="0" rIns="0" bIns="0" rtlCol="0">
                    <a:noAutofit/>
                  </a:bodyPr>
                  <a:lstStyle/>
                  <a:p>
                    <a:endParaRPr sz="1834"/>
                  </a:p>
                </p:txBody>
              </p:sp>
              <p:sp>
                <p:nvSpPr>
                  <p:cNvPr id="27" name="object 27"/>
                  <p:cNvSpPr/>
                  <p:nvPr/>
                </p:nvSpPr>
                <p:spPr>
                  <a:xfrm>
                    <a:off x="7528545" y="1133381"/>
                    <a:ext cx="279496" cy="0"/>
                  </a:xfrm>
                  <a:custGeom>
                    <a:avLst/>
                    <a:gdLst/>
                    <a:ahLst/>
                    <a:cxnLst/>
                    <a:rect l="l" t="t" r="r" b="b"/>
                    <a:pathLst>
                      <a:path w="274320">
                        <a:moveTo>
                          <a:pt x="0" y="0"/>
                        </a:moveTo>
                        <a:lnTo>
                          <a:pt x="274320" y="0"/>
                        </a:lnTo>
                      </a:path>
                    </a:pathLst>
                  </a:custGeom>
                  <a:ln w="19050">
                    <a:solidFill>
                      <a:srgbClr val="FFA500"/>
                    </a:solidFill>
                  </a:ln>
                </p:spPr>
                <p:txBody>
                  <a:bodyPr wrap="square" lIns="0" tIns="0" rIns="0" bIns="0" rtlCol="0">
                    <a:noAutofit/>
                  </a:bodyPr>
                  <a:lstStyle/>
                  <a:p>
                    <a:endParaRPr sz="1834"/>
                  </a:p>
                </p:txBody>
              </p:sp>
              <p:sp>
                <p:nvSpPr>
                  <p:cNvPr id="28" name="object 28"/>
                  <p:cNvSpPr txBox="1"/>
                  <p:nvPr/>
                </p:nvSpPr>
                <p:spPr>
                  <a:xfrm>
                    <a:off x="7934849" y="847545"/>
                    <a:ext cx="1044228" cy="384307"/>
                  </a:xfrm>
                  <a:prstGeom prst="rect">
                    <a:avLst/>
                  </a:prstGeom>
                </p:spPr>
                <p:txBody>
                  <a:bodyPr vert="horz" wrap="square" lIns="0" tIns="0" rIns="0" bIns="0" rtlCol="0">
                    <a:noAutofit/>
                  </a:bodyPr>
                  <a:lstStyle/>
                  <a:p>
                    <a:pPr marL="12940" marR="12940"/>
                    <a:r>
                      <a:rPr sz="1223" dirty="0">
                        <a:latin typeface="Arial"/>
                        <a:cs typeface="Arial"/>
                      </a:rPr>
                      <a:t>LC without IPF LC with IPF</a:t>
                    </a:r>
                  </a:p>
                </p:txBody>
              </p:sp>
              <p:sp>
                <p:nvSpPr>
                  <p:cNvPr id="29" name="object 31">
                    <a:extLst>
                      <a:ext uri="{FF2B5EF4-FFF2-40B4-BE49-F238E27FC236}">
                        <a16:creationId xmlns:a16="http://schemas.microsoft.com/office/drawing/2014/main" xmlns="" id="{AD62A7F2-5663-4DAE-A742-E1EC791D3D28}"/>
                      </a:ext>
                    </a:extLst>
                  </p:cNvPr>
                  <p:cNvSpPr txBox="1"/>
                  <p:nvPr/>
                </p:nvSpPr>
                <p:spPr>
                  <a:xfrm>
                    <a:off x="7235993" y="2527139"/>
                    <a:ext cx="1220970" cy="264845"/>
                  </a:xfrm>
                  <a:prstGeom prst="rect">
                    <a:avLst/>
                  </a:prstGeom>
                </p:spPr>
                <p:txBody>
                  <a:bodyPr vert="horz" wrap="square" lIns="0" tIns="0" rIns="0" bIns="0" rtlCol="0">
                    <a:noAutofit/>
                  </a:bodyPr>
                  <a:lstStyle/>
                  <a:p>
                    <a:pPr marL="12701"/>
                    <a:r>
                      <a:rPr lang="en-US" sz="1200" dirty="0">
                        <a:latin typeface="Arial"/>
                        <a:cs typeface="Arial"/>
                      </a:rPr>
                      <a:t>P</a:t>
                    </a:r>
                    <a:r>
                      <a:rPr sz="1200" dirty="0">
                        <a:latin typeface="Arial"/>
                        <a:cs typeface="Arial"/>
                      </a:rPr>
                      <a:t> </a:t>
                    </a:r>
                    <a:r>
                      <a:rPr lang="en-US" altLang="ko-KR" sz="1200" dirty="0">
                        <a:latin typeface="Arial"/>
                        <a:cs typeface="Arial"/>
                      </a:rPr>
                      <a:t>= 0.008</a:t>
                    </a:r>
                    <a:endParaRPr sz="1200" dirty="0">
                      <a:latin typeface="Arial"/>
                      <a:cs typeface="Arial"/>
                    </a:endParaRPr>
                  </a:p>
                </p:txBody>
              </p:sp>
            </p:grpSp>
          </p:grpSp>
        </p:grpSp>
      </p:grpSp>
      <p:sp>
        <p:nvSpPr>
          <p:cNvPr id="57" name="TextBox 56">
            <a:extLst>
              <a:ext uri="{FF2B5EF4-FFF2-40B4-BE49-F238E27FC236}">
                <a16:creationId xmlns:a16="http://schemas.microsoft.com/office/drawing/2014/main" xmlns="" id="{25654D92-E080-4140-A14B-51A55702471F}"/>
              </a:ext>
            </a:extLst>
          </p:cNvPr>
          <p:cNvSpPr txBox="1"/>
          <p:nvPr/>
        </p:nvSpPr>
        <p:spPr>
          <a:xfrm>
            <a:off x="238124" y="142875"/>
            <a:ext cx="252336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S1A Fig.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object 21"/>
          <p:cNvSpPr txBox="1"/>
          <p:nvPr/>
        </p:nvSpPr>
        <p:spPr>
          <a:xfrm>
            <a:off x="2811736" y="2679039"/>
            <a:ext cx="143718" cy="1499922"/>
          </a:xfrm>
          <a:prstGeom prst="rect">
            <a:avLst/>
          </a:prstGeom>
        </p:spPr>
        <p:txBody>
          <a:bodyPr vert="vert270" wrap="square" lIns="0" tIns="0" rIns="0" bIns="0" rtlCol="0">
            <a:noAutofit/>
          </a:bodyPr>
          <a:lstStyle/>
          <a:p>
            <a:pPr marL="12964"/>
            <a:endParaRPr sz="1225" dirty="0">
              <a:latin typeface="Arial"/>
              <a:cs typeface="Arial"/>
            </a:endParaRPr>
          </a:p>
        </p:txBody>
      </p:sp>
      <p:sp>
        <p:nvSpPr>
          <p:cNvPr id="24" name="object 24"/>
          <p:cNvSpPr/>
          <p:nvPr/>
        </p:nvSpPr>
        <p:spPr>
          <a:xfrm>
            <a:off x="7393055" y="1014712"/>
            <a:ext cx="1479072" cy="559529"/>
          </a:xfrm>
          <a:custGeom>
            <a:avLst/>
            <a:gdLst/>
            <a:ahLst/>
            <a:cxnLst/>
            <a:rect l="l" t="t" r="r" b="b"/>
            <a:pathLst>
              <a:path w="1448943" h="548131">
                <a:moveTo>
                  <a:pt x="0" y="0"/>
                </a:moveTo>
                <a:lnTo>
                  <a:pt x="1448943" y="0"/>
                </a:lnTo>
                <a:lnTo>
                  <a:pt x="1448943" y="548131"/>
                </a:lnTo>
                <a:lnTo>
                  <a:pt x="0" y="548131"/>
                </a:lnTo>
                <a:lnTo>
                  <a:pt x="0" y="0"/>
                </a:lnTo>
                <a:close/>
              </a:path>
            </a:pathLst>
          </a:custGeom>
          <a:solidFill>
            <a:srgbClr val="FFFFFF"/>
          </a:solidFill>
        </p:spPr>
        <p:txBody>
          <a:bodyPr wrap="square" lIns="0" tIns="0" rIns="0" bIns="0" rtlCol="0">
            <a:noAutofit/>
          </a:bodyPr>
          <a:lstStyle/>
          <a:p>
            <a:endParaRPr sz="1837"/>
          </a:p>
        </p:txBody>
      </p:sp>
      <p:grpSp>
        <p:nvGrpSpPr>
          <p:cNvPr id="69" name="그룹 68">
            <a:extLst>
              <a:ext uri="{FF2B5EF4-FFF2-40B4-BE49-F238E27FC236}">
                <a16:creationId xmlns:a16="http://schemas.microsoft.com/office/drawing/2014/main" xmlns="" id="{9792F261-0FDD-4A92-8B56-8D7737F950A4}"/>
              </a:ext>
            </a:extLst>
          </p:cNvPr>
          <p:cNvGrpSpPr/>
          <p:nvPr/>
        </p:nvGrpSpPr>
        <p:grpSpPr>
          <a:xfrm>
            <a:off x="3050991" y="601072"/>
            <a:ext cx="6090018" cy="5904621"/>
            <a:chOff x="2910974" y="753472"/>
            <a:chExt cx="6090018" cy="5904621"/>
          </a:xfrm>
        </p:grpSpPr>
        <p:sp>
          <p:nvSpPr>
            <p:cNvPr id="27" name="object 27"/>
            <p:cNvSpPr/>
            <p:nvPr/>
          </p:nvSpPr>
          <p:spPr>
            <a:xfrm>
              <a:off x="7521529" y="1130856"/>
              <a:ext cx="256948" cy="0"/>
            </a:xfrm>
            <a:custGeom>
              <a:avLst/>
              <a:gdLst/>
              <a:ahLst/>
              <a:cxnLst/>
              <a:rect l="l" t="t" r="r" b="b"/>
              <a:pathLst>
                <a:path w="251714">
                  <a:moveTo>
                    <a:pt x="0" y="0"/>
                  </a:moveTo>
                  <a:lnTo>
                    <a:pt x="251714" y="0"/>
                  </a:lnTo>
                </a:path>
              </a:pathLst>
            </a:custGeom>
            <a:ln w="19050">
              <a:solidFill>
                <a:srgbClr val="006400"/>
              </a:solidFill>
            </a:ln>
          </p:spPr>
          <p:txBody>
            <a:bodyPr wrap="square" lIns="0" tIns="0" rIns="0" bIns="0" rtlCol="0">
              <a:noAutofit/>
            </a:bodyPr>
            <a:lstStyle/>
            <a:p>
              <a:endParaRPr sz="1837"/>
            </a:p>
          </p:txBody>
        </p:sp>
        <p:grpSp>
          <p:nvGrpSpPr>
            <p:cNvPr id="68" name="그룹 67">
              <a:extLst>
                <a:ext uri="{FF2B5EF4-FFF2-40B4-BE49-F238E27FC236}">
                  <a16:creationId xmlns:a16="http://schemas.microsoft.com/office/drawing/2014/main" xmlns="" id="{D5E7163A-463C-4EB3-97F2-6A0BBBFBD084}"/>
                </a:ext>
              </a:extLst>
            </p:cNvPr>
            <p:cNvGrpSpPr/>
            <p:nvPr/>
          </p:nvGrpSpPr>
          <p:grpSpPr>
            <a:xfrm>
              <a:off x="2910974" y="753472"/>
              <a:ext cx="6090018" cy="5904621"/>
              <a:chOff x="2910974" y="753472"/>
              <a:chExt cx="6090018" cy="5904621"/>
            </a:xfrm>
          </p:grpSpPr>
          <p:sp>
            <p:nvSpPr>
              <p:cNvPr id="7" name="object 7"/>
              <p:cNvSpPr/>
              <p:nvPr/>
            </p:nvSpPr>
            <p:spPr>
              <a:xfrm>
                <a:off x="3475182" y="5715085"/>
                <a:ext cx="93340" cy="0"/>
              </a:xfrm>
              <a:custGeom>
                <a:avLst/>
                <a:gdLst/>
                <a:ahLst/>
                <a:cxnLst/>
                <a:rect l="l" t="t" r="r" b="b"/>
                <a:pathLst>
                  <a:path w="91439">
                    <a:moveTo>
                      <a:pt x="91439" y="0"/>
                    </a:moveTo>
                    <a:lnTo>
                      <a:pt x="0" y="0"/>
                    </a:lnTo>
                  </a:path>
                </a:pathLst>
              </a:custGeom>
              <a:ln w="9525">
                <a:solidFill>
                  <a:srgbClr val="000000"/>
                </a:solidFill>
              </a:ln>
            </p:spPr>
            <p:txBody>
              <a:bodyPr wrap="square" lIns="0" tIns="0" rIns="0" bIns="0" rtlCol="0">
                <a:noAutofit/>
              </a:bodyPr>
              <a:lstStyle/>
              <a:p>
                <a:endParaRPr sz="1837"/>
              </a:p>
            </p:txBody>
          </p:sp>
          <p:grpSp>
            <p:nvGrpSpPr>
              <p:cNvPr id="67" name="그룹 66">
                <a:extLst>
                  <a:ext uri="{FF2B5EF4-FFF2-40B4-BE49-F238E27FC236}">
                    <a16:creationId xmlns:a16="http://schemas.microsoft.com/office/drawing/2014/main" xmlns="" id="{AE3CB5B6-EC24-4BF2-8A99-12BCD1805024}"/>
                  </a:ext>
                </a:extLst>
              </p:cNvPr>
              <p:cNvGrpSpPr/>
              <p:nvPr/>
            </p:nvGrpSpPr>
            <p:grpSpPr>
              <a:xfrm>
                <a:off x="2910974" y="753472"/>
                <a:ext cx="6090018" cy="5904621"/>
                <a:chOff x="2910974" y="753472"/>
                <a:chExt cx="6090018" cy="5904621"/>
              </a:xfrm>
            </p:grpSpPr>
            <p:sp>
              <p:nvSpPr>
                <p:cNvPr id="8" name="object 8"/>
                <p:cNvSpPr/>
                <p:nvPr/>
              </p:nvSpPr>
              <p:spPr>
                <a:xfrm>
                  <a:off x="3475182" y="4760929"/>
                  <a:ext cx="93340" cy="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91439">
                      <a:moveTo>
                        <a:pt x="91439" y="0"/>
                      </a:moveTo>
                      <a:lnTo>
                        <a:pt x="0" y="0"/>
                      </a:lnTo>
                    </a:path>
                  </a:pathLst>
                </a:custGeom>
                <a:ln w="9525">
                  <a:solidFill>
                    <a:srgbClr val="000000"/>
                  </a:solidFill>
                </a:ln>
              </p:spPr>
              <p:txBody>
                <a:bodyPr wrap="square" lIns="0" tIns="0" rIns="0" bIns="0" rtlCol="0">
                  <a:noAutofit/>
                </a:bodyPr>
                <a:lstStyle/>
                <a:p>
                  <a:endParaRPr sz="1837"/>
                </a:p>
              </p:txBody>
            </p:sp>
            <p:sp>
              <p:nvSpPr>
                <p:cNvPr id="9" name="object 9"/>
                <p:cNvSpPr/>
                <p:nvPr/>
              </p:nvSpPr>
              <p:spPr>
                <a:xfrm>
                  <a:off x="3475182" y="3806773"/>
                  <a:ext cx="93340" cy="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91439">
                      <a:moveTo>
                        <a:pt x="91439" y="0"/>
                      </a:moveTo>
                      <a:lnTo>
                        <a:pt x="0" y="0"/>
                      </a:lnTo>
                    </a:path>
                  </a:pathLst>
                </a:custGeom>
                <a:ln w="9525">
                  <a:solidFill>
                    <a:srgbClr val="000000"/>
                  </a:solidFill>
                </a:ln>
              </p:spPr>
              <p:txBody>
                <a:bodyPr wrap="square" lIns="0" tIns="0" rIns="0" bIns="0" rtlCol="0">
                  <a:noAutofit/>
                </a:bodyPr>
                <a:lstStyle/>
                <a:p>
                  <a:endParaRPr sz="1837"/>
                </a:p>
              </p:txBody>
            </p:sp>
            <p:sp>
              <p:nvSpPr>
                <p:cNvPr id="10" name="object 10"/>
                <p:cNvSpPr/>
                <p:nvPr/>
              </p:nvSpPr>
              <p:spPr>
                <a:xfrm>
                  <a:off x="3475182" y="2852616"/>
                  <a:ext cx="93340" cy="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91439">
                      <a:moveTo>
                        <a:pt x="91439" y="0"/>
                      </a:moveTo>
                      <a:lnTo>
                        <a:pt x="0" y="0"/>
                      </a:lnTo>
                    </a:path>
                  </a:pathLst>
                </a:custGeom>
                <a:ln w="9525">
                  <a:solidFill>
                    <a:srgbClr val="000000"/>
                  </a:solidFill>
                </a:ln>
              </p:spPr>
              <p:txBody>
                <a:bodyPr wrap="square" lIns="0" tIns="0" rIns="0" bIns="0" rtlCol="0">
                  <a:noAutofit/>
                </a:bodyPr>
                <a:lstStyle/>
                <a:p>
                  <a:endParaRPr sz="1837"/>
                </a:p>
              </p:txBody>
            </p:sp>
            <p:sp>
              <p:nvSpPr>
                <p:cNvPr id="11" name="object 11"/>
                <p:cNvSpPr/>
                <p:nvPr/>
              </p:nvSpPr>
              <p:spPr>
                <a:xfrm>
                  <a:off x="3475182" y="1898460"/>
                  <a:ext cx="93340" cy="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91439">
                      <a:moveTo>
                        <a:pt x="91439" y="0"/>
                      </a:moveTo>
                      <a:lnTo>
                        <a:pt x="0" y="0"/>
                      </a:lnTo>
                    </a:path>
                  </a:pathLst>
                </a:custGeom>
                <a:ln w="9525">
                  <a:solidFill>
                    <a:srgbClr val="000000"/>
                  </a:solidFill>
                </a:ln>
              </p:spPr>
              <p:txBody>
                <a:bodyPr wrap="square" lIns="0" tIns="0" rIns="0" bIns="0" rtlCol="0">
                  <a:noAutofit/>
                </a:bodyPr>
                <a:lstStyle/>
                <a:p>
                  <a:endParaRPr sz="1837"/>
                </a:p>
              </p:txBody>
            </p:sp>
            <p:sp>
              <p:nvSpPr>
                <p:cNvPr id="12" name="object 12"/>
                <p:cNvSpPr/>
                <p:nvPr/>
              </p:nvSpPr>
              <p:spPr>
                <a:xfrm>
                  <a:off x="3475182" y="944303"/>
                  <a:ext cx="93340" cy="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91439">
                      <a:moveTo>
                        <a:pt x="91439" y="0"/>
                      </a:moveTo>
                      <a:lnTo>
                        <a:pt x="0" y="0"/>
                      </a:lnTo>
                    </a:path>
                  </a:pathLst>
                </a:custGeom>
                <a:ln w="9525">
                  <a:solidFill>
                    <a:srgbClr val="000000"/>
                  </a:solidFill>
                </a:ln>
              </p:spPr>
              <p:txBody>
                <a:bodyPr wrap="square" lIns="0" tIns="0" rIns="0" bIns="0" rtlCol="0">
                  <a:noAutofit/>
                </a:bodyPr>
                <a:lstStyle/>
                <a:p>
                  <a:endParaRPr sz="1837"/>
                </a:p>
              </p:txBody>
            </p:sp>
            <p:grpSp>
              <p:nvGrpSpPr>
                <p:cNvPr id="66" name="그룹 65">
                  <a:extLst>
                    <a:ext uri="{FF2B5EF4-FFF2-40B4-BE49-F238E27FC236}">
                      <a16:creationId xmlns:a16="http://schemas.microsoft.com/office/drawing/2014/main" xmlns="" id="{B3A6FCC6-88A6-4DAB-9430-C7D640CE5FA7}"/>
                    </a:ext>
                  </a:extLst>
                </p:cNvPr>
                <p:cNvGrpSpPr/>
                <p:nvPr/>
              </p:nvGrpSpPr>
              <p:grpSpPr>
                <a:xfrm>
                  <a:off x="2910974" y="753472"/>
                  <a:ext cx="6090018" cy="5904621"/>
                  <a:chOff x="2910974" y="753472"/>
                  <a:chExt cx="6090018" cy="5904621"/>
                </a:xfrm>
              </p:grpSpPr>
              <p:sp>
                <p:nvSpPr>
                  <p:cNvPr id="2" name="object 2"/>
                  <p:cNvSpPr txBox="1"/>
                  <p:nvPr/>
                </p:nvSpPr>
                <p:spPr>
                  <a:xfrm>
                    <a:off x="3713461" y="6086378"/>
                    <a:ext cx="112787" cy="198350"/>
                  </a:xfrm>
                  <a:prstGeom prst="rect">
                    <a:avLst/>
                  </a:prstGeom>
                </p:spPr>
                <p:txBody>
                  <a:bodyPr vert="horz" wrap="square" lIns="0" tIns="0" rIns="0" bIns="0" rtlCol="0">
                    <a:noAutofit/>
                  </a:bodyPr>
                  <a:lstStyle/>
                  <a:p>
                    <a:pPr marL="12964"/>
                    <a:r>
                      <a:rPr sz="1225" dirty="0">
                        <a:latin typeface="Arial"/>
                        <a:cs typeface="Arial"/>
                      </a:rPr>
                      <a:t>0</a:t>
                    </a:r>
                    <a:endParaRPr sz="1225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3" name="object 3"/>
                  <p:cNvSpPr txBox="1"/>
                  <p:nvPr/>
                </p:nvSpPr>
                <p:spPr>
                  <a:xfrm>
                    <a:off x="5149751" y="6086378"/>
                    <a:ext cx="198999" cy="198350"/>
                  </a:xfrm>
                  <a:prstGeom prst="rect">
                    <a:avLst/>
                  </a:prstGeom>
                </p:spPr>
                <p:txBody>
                  <a:bodyPr vert="horz" wrap="square" lIns="0" tIns="0" rIns="0" bIns="0" rtlCol="0">
                    <a:noAutofit/>
                  </a:bodyPr>
                  <a:lstStyle/>
                  <a:p>
                    <a:pPr marL="12964"/>
                    <a:r>
                      <a:rPr sz="1225" dirty="0">
                        <a:latin typeface="Arial"/>
                        <a:cs typeface="Arial"/>
                      </a:rPr>
                      <a:t>50</a:t>
                    </a:r>
                    <a:endParaRPr sz="1225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4" name="object 4"/>
                  <p:cNvSpPr txBox="1"/>
                  <p:nvPr/>
                </p:nvSpPr>
                <p:spPr>
                  <a:xfrm>
                    <a:off x="6585913" y="6086378"/>
                    <a:ext cx="285858" cy="198350"/>
                  </a:xfrm>
                  <a:prstGeom prst="rect">
                    <a:avLst/>
                  </a:prstGeom>
                </p:spPr>
                <p:txBody>
                  <a:bodyPr vert="horz" wrap="square" lIns="0" tIns="0" rIns="0" bIns="0" rtlCol="0">
                    <a:noAutofit/>
                  </a:bodyPr>
                  <a:lstStyle/>
                  <a:p>
                    <a:pPr marL="12964"/>
                    <a:r>
                      <a:rPr sz="1225" dirty="0">
                        <a:latin typeface="Arial"/>
                        <a:cs typeface="Arial"/>
                      </a:rPr>
                      <a:t>100</a:t>
                    </a:r>
                  </a:p>
                </p:txBody>
              </p:sp>
              <p:sp>
                <p:nvSpPr>
                  <p:cNvPr id="5" name="object 5"/>
                  <p:cNvSpPr txBox="1"/>
                  <p:nvPr/>
                </p:nvSpPr>
                <p:spPr>
                  <a:xfrm>
                    <a:off x="8065244" y="6086378"/>
                    <a:ext cx="285858" cy="198350"/>
                  </a:xfrm>
                  <a:prstGeom prst="rect">
                    <a:avLst/>
                  </a:prstGeom>
                </p:spPr>
                <p:txBody>
                  <a:bodyPr vert="horz" wrap="square" lIns="0" tIns="0" rIns="0" bIns="0" rtlCol="0">
                    <a:noAutofit/>
                  </a:bodyPr>
                  <a:lstStyle/>
                  <a:p>
                    <a:pPr marL="12964"/>
                    <a:r>
                      <a:rPr sz="1225" dirty="0">
                        <a:latin typeface="Arial"/>
                        <a:cs typeface="Arial"/>
                      </a:rPr>
                      <a:t>150</a:t>
                    </a:r>
                  </a:p>
                </p:txBody>
              </p:sp>
              <p:sp>
                <p:nvSpPr>
                  <p:cNvPr id="13" name="object 13"/>
                  <p:cNvSpPr txBox="1"/>
                  <p:nvPr/>
                </p:nvSpPr>
                <p:spPr>
                  <a:xfrm>
                    <a:off x="3188934" y="5594002"/>
                    <a:ext cx="198350" cy="242428"/>
                  </a:xfrm>
                  <a:prstGeom prst="rect">
                    <a:avLst/>
                  </a:prstGeom>
                </p:spPr>
                <p:txBody>
                  <a:bodyPr vert="vert270" wrap="square" lIns="0" tIns="0" rIns="0" bIns="0" rtlCol="0">
                    <a:noAutofit/>
                  </a:bodyPr>
                  <a:lstStyle/>
                  <a:p>
                    <a:pPr marL="12964"/>
                    <a:r>
                      <a:rPr sz="1225" dirty="0">
                        <a:latin typeface="Arial"/>
                        <a:cs typeface="Arial"/>
                      </a:rPr>
                      <a:t>0.0</a:t>
                    </a:r>
                    <a:endParaRPr sz="1225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14" name="object 14"/>
                  <p:cNvSpPr txBox="1"/>
                  <p:nvPr/>
                </p:nvSpPr>
                <p:spPr>
                  <a:xfrm>
                    <a:off x="3188934" y="4639845"/>
                    <a:ext cx="198350" cy="242428"/>
                  </a:xfrm>
                  <a:prstGeom prst="rect">
                    <a:avLst/>
                  </a:prstGeom>
                </p:spPr>
                <p:txBody>
                  <a:bodyPr vert="vert270" wrap="square" lIns="0" tIns="0" rIns="0" bIns="0" rtlCol="0">
                    <a:noAutofit/>
                  </a:bodyPr>
                  <a:lstStyle/>
                  <a:p>
                    <a:pPr marL="12964"/>
                    <a:r>
                      <a:rPr sz="1225" dirty="0">
                        <a:latin typeface="Arial"/>
                        <a:cs typeface="Arial"/>
                      </a:rPr>
                      <a:t>0.2</a:t>
                    </a:r>
                    <a:endParaRPr sz="1225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15" name="object 15"/>
                  <p:cNvSpPr txBox="1"/>
                  <p:nvPr/>
                </p:nvSpPr>
                <p:spPr>
                  <a:xfrm>
                    <a:off x="3188934" y="3685688"/>
                    <a:ext cx="198350" cy="242428"/>
                  </a:xfrm>
                  <a:prstGeom prst="rect">
                    <a:avLst/>
                  </a:prstGeom>
                </p:spPr>
                <p:txBody>
                  <a:bodyPr vert="vert270" wrap="square" lIns="0" tIns="0" rIns="0" bIns="0" rtlCol="0">
                    <a:noAutofit/>
                  </a:bodyPr>
                  <a:lstStyle/>
                  <a:p>
                    <a:pPr marL="12964"/>
                    <a:r>
                      <a:rPr sz="1225" dirty="0">
                        <a:latin typeface="Arial"/>
                        <a:cs typeface="Arial"/>
                      </a:rPr>
                      <a:t>0.4</a:t>
                    </a:r>
                    <a:endParaRPr sz="1225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16" name="object 16"/>
                  <p:cNvSpPr txBox="1"/>
                  <p:nvPr/>
                </p:nvSpPr>
                <p:spPr>
                  <a:xfrm>
                    <a:off x="3188934" y="2731531"/>
                    <a:ext cx="198350" cy="242428"/>
                  </a:xfrm>
                  <a:prstGeom prst="rect">
                    <a:avLst/>
                  </a:prstGeom>
                </p:spPr>
                <p:txBody>
                  <a:bodyPr vert="vert270" wrap="square" lIns="0" tIns="0" rIns="0" bIns="0" rtlCol="0">
                    <a:noAutofit/>
                  </a:bodyPr>
                  <a:lstStyle/>
                  <a:p>
                    <a:pPr marL="12964"/>
                    <a:r>
                      <a:rPr sz="1225" dirty="0">
                        <a:latin typeface="Arial"/>
                        <a:cs typeface="Arial"/>
                      </a:rPr>
                      <a:t>0.6</a:t>
                    </a:r>
                    <a:endParaRPr sz="1225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17" name="object 17"/>
                  <p:cNvSpPr txBox="1"/>
                  <p:nvPr/>
                </p:nvSpPr>
                <p:spPr>
                  <a:xfrm>
                    <a:off x="3188934" y="1777376"/>
                    <a:ext cx="198350" cy="242428"/>
                  </a:xfrm>
                  <a:prstGeom prst="rect">
                    <a:avLst/>
                  </a:prstGeom>
                </p:spPr>
                <p:txBody>
                  <a:bodyPr vert="vert270" wrap="square" lIns="0" tIns="0" rIns="0" bIns="0" rtlCol="0">
                    <a:noAutofit/>
                  </a:bodyPr>
                  <a:lstStyle/>
                  <a:p>
                    <a:pPr marL="12964"/>
                    <a:r>
                      <a:rPr sz="1225" dirty="0">
                        <a:latin typeface="Arial"/>
                        <a:cs typeface="Arial"/>
                      </a:rPr>
                      <a:t>0.8</a:t>
                    </a:r>
                    <a:endParaRPr sz="1225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18" name="object 18"/>
                  <p:cNvSpPr txBox="1"/>
                  <p:nvPr/>
                </p:nvSpPr>
                <p:spPr>
                  <a:xfrm>
                    <a:off x="3188934" y="823219"/>
                    <a:ext cx="198350" cy="242428"/>
                  </a:xfrm>
                  <a:prstGeom prst="rect">
                    <a:avLst/>
                  </a:prstGeom>
                </p:spPr>
                <p:txBody>
                  <a:bodyPr vert="vert270" wrap="square" lIns="0" tIns="0" rIns="0" bIns="0" rtlCol="0">
                    <a:noAutofit/>
                  </a:bodyPr>
                  <a:lstStyle/>
                  <a:p>
                    <a:pPr marL="12964"/>
                    <a:r>
                      <a:rPr sz="1225" dirty="0">
                        <a:latin typeface="Arial"/>
                        <a:cs typeface="Arial"/>
                      </a:rPr>
                      <a:t>1.0</a:t>
                    </a:r>
                    <a:endParaRPr sz="1225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19" name="object 19"/>
                  <p:cNvSpPr/>
                  <p:nvPr/>
                </p:nvSpPr>
                <p:spPr>
                  <a:xfrm>
                    <a:off x="3568523" y="753472"/>
                    <a:ext cx="5432469" cy="5152445"/>
                  </a:xfrm>
                  <a:custGeom>
                    <a:avLst/>
                    <a:gdLst/>
                    <a:ahLst/>
                    <a:cxnLst/>
                    <a:rect l="l" t="t" r="r" b="b"/>
                    <a:pathLst>
                      <a:path w="5321808" h="5047488">
                        <a:moveTo>
                          <a:pt x="0" y="5047488"/>
                        </a:moveTo>
                        <a:lnTo>
                          <a:pt x="5321808" y="5047488"/>
                        </a:lnTo>
                        <a:lnTo>
                          <a:pt x="5321808" y="0"/>
                        </a:lnTo>
                        <a:lnTo>
                          <a:pt x="0" y="0"/>
                        </a:lnTo>
                        <a:lnTo>
                          <a:pt x="0" y="5047488"/>
                        </a:lnTo>
                      </a:path>
                    </a:pathLst>
                  </a:custGeom>
                  <a:ln w="9525">
                    <a:solidFill>
                      <a:srgbClr val="000000"/>
                    </a:solidFill>
                  </a:ln>
                </p:spPr>
                <p:txBody>
                  <a:bodyPr wrap="square" lIns="0" tIns="0" rIns="0" bIns="0" rtlCol="0">
                    <a:noAutofit/>
                  </a:bodyPr>
                  <a:lstStyle/>
                  <a:p>
                    <a:endParaRPr sz="1837" dirty="0"/>
                  </a:p>
                </p:txBody>
              </p:sp>
              <p:sp>
                <p:nvSpPr>
                  <p:cNvPr id="20" name="object 20"/>
                  <p:cNvSpPr txBox="1"/>
                  <p:nvPr/>
                </p:nvSpPr>
                <p:spPr>
                  <a:xfrm>
                    <a:off x="5792121" y="6459743"/>
                    <a:ext cx="985919" cy="198350"/>
                  </a:xfrm>
                  <a:prstGeom prst="rect">
                    <a:avLst/>
                  </a:prstGeom>
                </p:spPr>
                <p:txBody>
                  <a:bodyPr vert="horz" wrap="square" lIns="0" tIns="0" rIns="0" bIns="0" rtlCol="0">
                    <a:noAutofit/>
                  </a:bodyPr>
                  <a:lstStyle/>
                  <a:p>
                    <a:pPr marL="12964"/>
                    <a:r>
                      <a:rPr sz="1225" dirty="0">
                        <a:latin typeface="Arial"/>
                        <a:cs typeface="Arial"/>
                      </a:rPr>
                      <a:t>Time(months)</a:t>
                    </a:r>
                  </a:p>
                </p:txBody>
              </p:sp>
              <p:sp>
                <p:nvSpPr>
                  <p:cNvPr id="22" name="object 22"/>
                  <p:cNvSpPr/>
                  <p:nvPr/>
                </p:nvSpPr>
                <p:spPr>
                  <a:xfrm>
                    <a:off x="3769724" y="944303"/>
                    <a:ext cx="4680942" cy="1123079"/>
                  </a:xfrm>
                  <a:custGeom>
                    <a:avLst/>
                    <a:gdLst/>
                    <a:ahLst/>
                    <a:cxnLst/>
                    <a:rect l="l" t="t" r="r" b="b"/>
                    <a:pathLst>
                      <a:path w="4585589" h="1100201">
                        <a:moveTo>
                          <a:pt x="0" y="0"/>
                        </a:moveTo>
                        <a:lnTo>
                          <a:pt x="272415" y="0"/>
                        </a:lnTo>
                        <a:lnTo>
                          <a:pt x="272415" y="32893"/>
                        </a:lnTo>
                        <a:lnTo>
                          <a:pt x="321691" y="32893"/>
                        </a:lnTo>
                        <a:lnTo>
                          <a:pt x="321691" y="66040"/>
                        </a:lnTo>
                        <a:lnTo>
                          <a:pt x="359409" y="66040"/>
                        </a:lnTo>
                        <a:lnTo>
                          <a:pt x="359409" y="99441"/>
                        </a:lnTo>
                        <a:lnTo>
                          <a:pt x="507238" y="99441"/>
                        </a:lnTo>
                        <a:lnTo>
                          <a:pt x="507238" y="133350"/>
                        </a:lnTo>
                        <a:lnTo>
                          <a:pt x="623188" y="133350"/>
                        </a:lnTo>
                        <a:lnTo>
                          <a:pt x="623188" y="168021"/>
                        </a:lnTo>
                        <a:lnTo>
                          <a:pt x="629031" y="168021"/>
                        </a:lnTo>
                        <a:lnTo>
                          <a:pt x="629031" y="202692"/>
                        </a:lnTo>
                        <a:lnTo>
                          <a:pt x="649224" y="202692"/>
                        </a:lnTo>
                        <a:lnTo>
                          <a:pt x="649224" y="237617"/>
                        </a:lnTo>
                        <a:lnTo>
                          <a:pt x="794257" y="237617"/>
                        </a:lnTo>
                        <a:lnTo>
                          <a:pt x="794257" y="273304"/>
                        </a:lnTo>
                        <a:lnTo>
                          <a:pt x="805814" y="273304"/>
                        </a:lnTo>
                        <a:lnTo>
                          <a:pt x="805814" y="309372"/>
                        </a:lnTo>
                        <a:lnTo>
                          <a:pt x="852169" y="309372"/>
                        </a:lnTo>
                        <a:lnTo>
                          <a:pt x="852169" y="345440"/>
                        </a:lnTo>
                        <a:lnTo>
                          <a:pt x="913002" y="345440"/>
                        </a:lnTo>
                        <a:lnTo>
                          <a:pt x="913002" y="382143"/>
                        </a:lnTo>
                        <a:lnTo>
                          <a:pt x="924687" y="382143"/>
                        </a:lnTo>
                        <a:lnTo>
                          <a:pt x="924687" y="418846"/>
                        </a:lnTo>
                        <a:lnTo>
                          <a:pt x="1040638" y="418846"/>
                        </a:lnTo>
                        <a:lnTo>
                          <a:pt x="1040638" y="457200"/>
                        </a:lnTo>
                        <a:lnTo>
                          <a:pt x="1069594" y="457200"/>
                        </a:lnTo>
                        <a:lnTo>
                          <a:pt x="1069594" y="495554"/>
                        </a:lnTo>
                        <a:lnTo>
                          <a:pt x="1420368" y="495554"/>
                        </a:lnTo>
                        <a:lnTo>
                          <a:pt x="1420368" y="540004"/>
                        </a:lnTo>
                        <a:lnTo>
                          <a:pt x="1452245" y="540004"/>
                        </a:lnTo>
                        <a:lnTo>
                          <a:pt x="1452245" y="585851"/>
                        </a:lnTo>
                        <a:lnTo>
                          <a:pt x="1542033" y="585851"/>
                        </a:lnTo>
                        <a:lnTo>
                          <a:pt x="1542033" y="633476"/>
                        </a:lnTo>
                        <a:lnTo>
                          <a:pt x="1657985" y="633476"/>
                        </a:lnTo>
                        <a:lnTo>
                          <a:pt x="1657985" y="685165"/>
                        </a:lnTo>
                        <a:lnTo>
                          <a:pt x="1660906" y="685165"/>
                        </a:lnTo>
                        <a:lnTo>
                          <a:pt x="1660906" y="736981"/>
                        </a:lnTo>
                        <a:lnTo>
                          <a:pt x="1689862" y="736981"/>
                        </a:lnTo>
                        <a:lnTo>
                          <a:pt x="1689862" y="790194"/>
                        </a:lnTo>
                        <a:lnTo>
                          <a:pt x="1698625" y="790194"/>
                        </a:lnTo>
                        <a:lnTo>
                          <a:pt x="1698625" y="843407"/>
                        </a:lnTo>
                        <a:lnTo>
                          <a:pt x="1918843" y="843407"/>
                        </a:lnTo>
                        <a:lnTo>
                          <a:pt x="1918843" y="901446"/>
                        </a:lnTo>
                        <a:lnTo>
                          <a:pt x="2223262" y="901446"/>
                        </a:lnTo>
                        <a:lnTo>
                          <a:pt x="2223262" y="972566"/>
                        </a:lnTo>
                        <a:lnTo>
                          <a:pt x="2753614" y="972566"/>
                        </a:lnTo>
                        <a:lnTo>
                          <a:pt x="2753614" y="1100201"/>
                        </a:lnTo>
                        <a:lnTo>
                          <a:pt x="4585589" y="1100201"/>
                        </a:lnTo>
                      </a:path>
                    </a:pathLst>
                  </a:custGeom>
                  <a:ln w="19050">
                    <a:solidFill>
                      <a:srgbClr val="A020F0"/>
                    </a:solidFill>
                  </a:ln>
                </p:spPr>
                <p:txBody>
                  <a:bodyPr wrap="square" lIns="0" tIns="0" rIns="0" bIns="0" rtlCol="0">
                    <a:noAutofit/>
                  </a:bodyPr>
                  <a:lstStyle/>
                  <a:p>
                    <a:endParaRPr sz="1837" dirty="0"/>
                  </a:p>
                </p:txBody>
              </p:sp>
              <p:sp>
                <p:nvSpPr>
                  <p:cNvPr id="23" name="object 23"/>
                  <p:cNvSpPr/>
                  <p:nvPr/>
                </p:nvSpPr>
                <p:spPr>
                  <a:xfrm>
                    <a:off x="3769724" y="944303"/>
                    <a:ext cx="3751805" cy="2245898"/>
                  </a:xfrm>
                  <a:custGeom>
                    <a:avLst/>
                    <a:gdLst/>
                    <a:ahLst/>
                    <a:cxnLst/>
                    <a:rect l="l" t="t" r="r" b="b"/>
                    <a:pathLst>
                      <a:path w="3675379" h="2200148">
                        <a:moveTo>
                          <a:pt x="0" y="0"/>
                        </a:moveTo>
                        <a:lnTo>
                          <a:pt x="75310" y="0"/>
                        </a:lnTo>
                        <a:lnTo>
                          <a:pt x="75310" y="139573"/>
                        </a:lnTo>
                        <a:lnTo>
                          <a:pt x="101472" y="139573"/>
                        </a:lnTo>
                        <a:lnTo>
                          <a:pt x="101472" y="209296"/>
                        </a:lnTo>
                        <a:lnTo>
                          <a:pt x="234822" y="209296"/>
                        </a:lnTo>
                        <a:lnTo>
                          <a:pt x="234822" y="281305"/>
                        </a:lnTo>
                        <a:lnTo>
                          <a:pt x="452119" y="281305"/>
                        </a:lnTo>
                        <a:lnTo>
                          <a:pt x="452119" y="358267"/>
                        </a:lnTo>
                        <a:lnTo>
                          <a:pt x="486918" y="358267"/>
                        </a:lnTo>
                        <a:lnTo>
                          <a:pt x="486918" y="512445"/>
                        </a:lnTo>
                        <a:lnTo>
                          <a:pt x="504316" y="512445"/>
                        </a:lnTo>
                        <a:lnTo>
                          <a:pt x="504316" y="589534"/>
                        </a:lnTo>
                        <a:lnTo>
                          <a:pt x="620268" y="589534"/>
                        </a:lnTo>
                        <a:lnTo>
                          <a:pt x="620268" y="671195"/>
                        </a:lnTo>
                        <a:lnTo>
                          <a:pt x="637666" y="671195"/>
                        </a:lnTo>
                        <a:lnTo>
                          <a:pt x="637666" y="752856"/>
                        </a:lnTo>
                        <a:lnTo>
                          <a:pt x="701420" y="752856"/>
                        </a:lnTo>
                        <a:lnTo>
                          <a:pt x="701420" y="836295"/>
                        </a:lnTo>
                        <a:lnTo>
                          <a:pt x="805814" y="836295"/>
                        </a:lnTo>
                        <a:lnTo>
                          <a:pt x="805814" y="921512"/>
                        </a:lnTo>
                        <a:lnTo>
                          <a:pt x="834770" y="921512"/>
                        </a:lnTo>
                        <a:lnTo>
                          <a:pt x="834770" y="1006856"/>
                        </a:lnTo>
                        <a:lnTo>
                          <a:pt x="863726" y="1006856"/>
                        </a:lnTo>
                        <a:lnTo>
                          <a:pt x="863726" y="1092073"/>
                        </a:lnTo>
                        <a:lnTo>
                          <a:pt x="991362" y="1092073"/>
                        </a:lnTo>
                        <a:lnTo>
                          <a:pt x="991362" y="1179449"/>
                        </a:lnTo>
                        <a:lnTo>
                          <a:pt x="1333373" y="1179449"/>
                        </a:lnTo>
                        <a:lnTo>
                          <a:pt x="1333373" y="1279271"/>
                        </a:lnTo>
                        <a:lnTo>
                          <a:pt x="1434845" y="1279271"/>
                        </a:lnTo>
                        <a:lnTo>
                          <a:pt x="1434845" y="1396365"/>
                        </a:lnTo>
                        <a:lnTo>
                          <a:pt x="1466723" y="1396365"/>
                        </a:lnTo>
                        <a:lnTo>
                          <a:pt x="1466723" y="1517777"/>
                        </a:lnTo>
                        <a:lnTo>
                          <a:pt x="1971039" y="1517777"/>
                        </a:lnTo>
                        <a:lnTo>
                          <a:pt x="1971039" y="1675511"/>
                        </a:lnTo>
                        <a:lnTo>
                          <a:pt x="2489835" y="1675511"/>
                        </a:lnTo>
                        <a:lnTo>
                          <a:pt x="2489835" y="1925320"/>
                        </a:lnTo>
                        <a:lnTo>
                          <a:pt x="2588387" y="1925320"/>
                        </a:lnTo>
                        <a:lnTo>
                          <a:pt x="2588387" y="2200148"/>
                        </a:lnTo>
                        <a:lnTo>
                          <a:pt x="3675379" y="2200148"/>
                        </a:lnTo>
                      </a:path>
                    </a:pathLst>
                  </a:custGeom>
                  <a:ln w="19050">
                    <a:solidFill>
                      <a:srgbClr val="006400"/>
                    </a:solidFill>
                  </a:ln>
                </p:spPr>
                <p:txBody>
                  <a:bodyPr wrap="square" lIns="0" tIns="0" rIns="0" bIns="0" rtlCol="0">
                    <a:noAutofit/>
                  </a:bodyPr>
                  <a:lstStyle/>
                  <a:p>
                    <a:endParaRPr sz="1837"/>
                  </a:p>
                </p:txBody>
              </p:sp>
              <p:sp>
                <p:nvSpPr>
                  <p:cNvPr id="26" name="object 26"/>
                  <p:cNvSpPr/>
                  <p:nvPr/>
                </p:nvSpPr>
                <p:spPr>
                  <a:xfrm>
                    <a:off x="7521529" y="944303"/>
                    <a:ext cx="256948" cy="0"/>
                  </a:xfrm>
                  <a:custGeom>
                    <a:avLst/>
                    <a:gdLst/>
                    <a:ahLst/>
                    <a:cxnLst/>
                    <a:rect l="l" t="t" r="r" b="b"/>
                    <a:pathLst>
                      <a:path w="251714">
                        <a:moveTo>
                          <a:pt x="0" y="0"/>
                        </a:moveTo>
                        <a:lnTo>
                          <a:pt x="251714" y="0"/>
                        </a:lnTo>
                      </a:path>
                    </a:pathLst>
                  </a:custGeom>
                  <a:ln w="19050">
                    <a:solidFill>
                      <a:srgbClr val="A020F0"/>
                    </a:solidFill>
                  </a:ln>
                </p:spPr>
                <p:txBody>
                  <a:bodyPr wrap="square" lIns="0" tIns="0" rIns="0" bIns="0" rtlCol="0">
                    <a:noAutofit/>
                  </a:bodyPr>
                  <a:lstStyle/>
                  <a:p>
                    <a:endParaRPr sz="1837"/>
                  </a:p>
                </p:txBody>
              </p:sp>
              <p:sp>
                <p:nvSpPr>
                  <p:cNvPr id="28" name="object 28"/>
                  <p:cNvSpPr txBox="1"/>
                  <p:nvPr/>
                </p:nvSpPr>
                <p:spPr>
                  <a:xfrm>
                    <a:off x="7846478" y="844670"/>
                    <a:ext cx="1106744" cy="443641"/>
                  </a:xfrm>
                  <a:prstGeom prst="rect">
                    <a:avLst/>
                  </a:prstGeom>
                </p:spPr>
                <p:txBody>
                  <a:bodyPr vert="horz" wrap="square" lIns="0" tIns="0" rIns="0" bIns="0" rtlCol="0">
                    <a:noAutofit/>
                  </a:bodyPr>
                  <a:lstStyle/>
                  <a:p>
                    <a:pPr marL="12964" marR="12964">
                      <a:lnSpc>
                        <a:spcPts val="1470"/>
                      </a:lnSpc>
                    </a:pPr>
                    <a:r>
                      <a:rPr sz="1225" dirty="0">
                        <a:latin typeface="Arial"/>
                        <a:cs typeface="Arial"/>
                      </a:rPr>
                      <a:t>LC without IP</a:t>
                    </a:r>
                    <a:r>
                      <a:rPr lang="en-US" sz="1225" dirty="0">
                        <a:latin typeface="Arial"/>
                        <a:cs typeface="Arial"/>
                      </a:rPr>
                      <a:t>F</a:t>
                    </a:r>
                    <a:r>
                      <a:rPr sz="1225" dirty="0">
                        <a:latin typeface="Arial"/>
                        <a:cs typeface="Arial"/>
                      </a:rPr>
                      <a:t> LC with IPF</a:t>
                    </a:r>
                  </a:p>
                </p:txBody>
              </p:sp>
              <p:sp>
                <p:nvSpPr>
                  <p:cNvPr id="29" name="object 31">
                    <a:extLst>
                      <a:ext uri="{FF2B5EF4-FFF2-40B4-BE49-F238E27FC236}">
                        <a16:creationId xmlns:a16="http://schemas.microsoft.com/office/drawing/2014/main" xmlns="" id="{F92CD4CD-48AC-4C97-AB07-5132F3BA6393}"/>
                      </a:ext>
                    </a:extLst>
                  </p:cNvPr>
                  <p:cNvSpPr txBox="1"/>
                  <p:nvPr/>
                </p:nvSpPr>
                <p:spPr>
                  <a:xfrm>
                    <a:off x="7235993" y="2527139"/>
                    <a:ext cx="1220970" cy="264845"/>
                  </a:xfrm>
                  <a:prstGeom prst="rect">
                    <a:avLst/>
                  </a:prstGeom>
                </p:spPr>
                <p:txBody>
                  <a:bodyPr vert="horz" wrap="square" lIns="0" tIns="0" rIns="0" bIns="0" rtlCol="0">
                    <a:noAutofit/>
                  </a:bodyPr>
                  <a:lstStyle/>
                  <a:p>
                    <a:pPr marL="12701"/>
                    <a:r>
                      <a:rPr lang="en-US" sz="1200" dirty="0">
                        <a:latin typeface="Arial"/>
                        <a:cs typeface="Arial"/>
                      </a:rPr>
                      <a:t>P</a:t>
                    </a:r>
                    <a:r>
                      <a:rPr sz="1200" dirty="0">
                        <a:latin typeface="Arial"/>
                        <a:cs typeface="Arial"/>
                      </a:rPr>
                      <a:t> </a:t>
                    </a:r>
                    <a:r>
                      <a:rPr lang="en-US" altLang="ko-KR" sz="1200" dirty="0">
                        <a:latin typeface="Arial"/>
                        <a:cs typeface="Arial"/>
                      </a:rPr>
                      <a:t>= 0.007</a:t>
                    </a:r>
                    <a:endParaRPr sz="1200" dirty="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30" name="object 21">
                    <a:extLst>
                      <a:ext uri="{FF2B5EF4-FFF2-40B4-BE49-F238E27FC236}">
                        <a16:creationId xmlns:a16="http://schemas.microsoft.com/office/drawing/2014/main" xmlns="" id="{8AAF9D88-EF19-4BAC-81E8-0892C75F5181}"/>
                      </a:ext>
                    </a:extLst>
                  </p:cNvPr>
                  <p:cNvSpPr txBox="1"/>
                  <p:nvPr/>
                </p:nvSpPr>
                <p:spPr>
                  <a:xfrm>
                    <a:off x="2910974" y="1988794"/>
                    <a:ext cx="262507" cy="2681800"/>
                  </a:xfrm>
                  <a:prstGeom prst="rect">
                    <a:avLst/>
                  </a:prstGeom>
                </p:spPr>
                <p:txBody>
                  <a:bodyPr vert="vert270" wrap="square" lIns="0" tIns="0" rIns="0" bIns="0" rtlCol="0">
                    <a:noAutofit/>
                  </a:bodyPr>
                  <a:lstStyle/>
                  <a:p>
                    <a:pPr marL="12940"/>
                    <a:r>
                      <a:rPr sz="1223" dirty="0">
                        <a:latin typeface="Arial"/>
                        <a:cs typeface="Arial"/>
                      </a:rPr>
                      <a:t>Cancer specific</a:t>
                    </a:r>
                    <a:r>
                      <a:rPr lang="en-US" altLang="ko-KR" sz="1223" dirty="0">
                        <a:latin typeface="Arial"/>
                        <a:cs typeface="Arial"/>
                      </a:rPr>
                      <a:t> </a:t>
                    </a:r>
                    <a:r>
                      <a:rPr lang="ko-KR" altLang="en-US" sz="1223" dirty="0">
                        <a:latin typeface="Arial"/>
                        <a:cs typeface="Arial"/>
                      </a:rPr>
                      <a:t> </a:t>
                    </a:r>
                    <a:r>
                      <a:rPr lang="en-US" altLang="ko-KR" sz="1223" dirty="0">
                        <a:latin typeface="Arial"/>
                        <a:cs typeface="Arial"/>
                      </a:rPr>
                      <a:t>survival </a:t>
                    </a:r>
                    <a:r>
                      <a:rPr lang="en-US" altLang="ko-KR" sz="1223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(Probability)</a:t>
                    </a:r>
                    <a:endParaRPr sz="1223" dirty="0">
                      <a:latin typeface="Arial"/>
                      <a:cs typeface="Arial"/>
                    </a:endParaRPr>
                  </a:p>
                </p:txBody>
              </p:sp>
            </p:grpSp>
          </p:grpSp>
        </p:grpSp>
      </p:grpSp>
      <p:sp>
        <p:nvSpPr>
          <p:cNvPr id="71" name="TextBox 70">
            <a:extLst>
              <a:ext uri="{FF2B5EF4-FFF2-40B4-BE49-F238E27FC236}">
                <a16:creationId xmlns:a16="http://schemas.microsoft.com/office/drawing/2014/main" xmlns="" id="{462A43FE-A144-4310-BD81-E96BF4013506}"/>
              </a:ext>
            </a:extLst>
          </p:cNvPr>
          <p:cNvSpPr txBox="1"/>
          <p:nvPr/>
        </p:nvSpPr>
        <p:spPr>
          <a:xfrm>
            <a:off x="238124" y="142875"/>
            <a:ext cx="252336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S1B Fig.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61</Words>
  <Application>Microsoft Office PowerPoint</Application>
  <PresentationFormat>Custom</PresentationFormat>
  <Paragraphs>30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테마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송명진</dc:creator>
  <cp:lastModifiedBy>Manikandan R</cp:lastModifiedBy>
  <cp:revision>2</cp:revision>
  <dcterms:created xsi:type="dcterms:W3CDTF">2020-05-19T00:58:35Z</dcterms:created>
  <dcterms:modified xsi:type="dcterms:W3CDTF">2020-06-21T05:46:26Z</dcterms:modified>
</cp:coreProperties>
</file>